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9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embeddedFontLst>
    <p:embeddedFont>
      <p:font typeface="Bebas Neue" panose="020B0606020202050201" pitchFamily="34" charset="0"/>
      <p:regular r:id="rId4"/>
    </p:embeddedFont>
    <p:embeddedFont>
      <p:font typeface="Hind" panose="02000000000000000000" pitchFamily="2" charset="0"/>
      <p:regular r:id="rId5"/>
      <p:bold r:id="rId6"/>
    </p:embeddedFont>
    <p:embeddedFont>
      <p:font typeface="Inter" panose="020B0604020202020204" charset="0"/>
      <p:regular r:id="rId7"/>
      <p:bold r:id="rId8"/>
    </p:embeddedFont>
    <p:embeddedFont>
      <p:font typeface="Inter SemiBold" panose="020B0604020202020204" charset="0"/>
      <p:regular r:id="rId9"/>
      <p:bold r:id="rId10"/>
    </p:embeddedFont>
    <p:embeddedFont>
      <p:font typeface="Roboto Condensed" panose="02000000000000000000" pitchFamily="2" charset="0"/>
      <p:regular r:id="rId11"/>
      <p:bold r:id="rId12"/>
      <p:italic r:id="rId13"/>
      <p:boldItalic r:id="rId14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9" roundtripDataSignature="AMtx7mgYfc4ulmYo8T5HNxUUdT34wHVCx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548" y="4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3" Type="http://schemas.openxmlformats.org/officeDocument/2006/relationships/notesMaster" Target="notesMasters/notesMaster1.xml"/><Relationship Id="rId21" Type="http://schemas.openxmlformats.org/officeDocument/2006/relationships/viewProps" Target="viewProps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2" Type="http://schemas.openxmlformats.org/officeDocument/2006/relationships/slide" Target="slides/slide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23" Type="http://schemas.openxmlformats.org/officeDocument/2006/relationships/tableStyles" Target="tableStyles.xml"/><Relationship Id="rId10" Type="http://schemas.openxmlformats.org/officeDocument/2006/relationships/font" Target="fonts/font7.fntdata"/><Relationship Id="rId19" Type="http://customschemas.google.com/relationships/presentationmetadata" Target="meta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font" Target="fonts/font11.fntdata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Google Shape;614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15" name="Google Shape;615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9.png"/><Relationship Id="rId1" Type="http://schemas.openxmlformats.org/officeDocument/2006/relationships/slideMaster" Target="../slideMasters/slideMaster1.xml"/></Relationships>
</file>

<file path=ppt/slideLayouts/_rels/slideLayout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9.png"/><Relationship Id="rId1" Type="http://schemas.openxmlformats.org/officeDocument/2006/relationships/slideMaster" Target="../slideMasters/slideMaster1.xml"/></Relationships>
</file>

<file path=ppt/slideLayouts/_rels/slideLayout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7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7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7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yellow">
  <p:cSld name="b. left text and photo yellow">
    <p:bg>
      <p:bgPr>
        <a:solidFill>
          <a:srgbClr val="FFD200"/>
        </a:solidFill>
        <a:effectLst/>
      </p:bgPr>
    </p:bg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6" name="Google Shape;16;p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Google Shape;17;p3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  <p:txBody>
          <a:bodyPr/>
          <a:lstStyle/>
          <a:p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dark blue">
  <p:cSld name="b. left text and photo dark blue">
    <p:bg>
      <p:bgPr>
        <a:solidFill>
          <a:srgbClr val="001E82"/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2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61" name="Google Shape;61;p12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62" name="Google Shape;62;p1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dark green">
  <p:cSld name="b. left text and photo dark green">
    <p:bg>
      <p:bgPr>
        <a:solidFill>
          <a:srgbClr val="144835"/>
        </a:solidFill>
        <a:effectLst/>
      </p:bgPr>
    </p:bg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13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66" name="Google Shape;66;p13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67" name="Google Shape;67;p1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68" name="Google Shape;68;p13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orange">
  <p:cSld name="b. left text and photo orange">
    <p:bg>
      <p:bgPr>
        <a:solidFill>
          <a:srgbClr val="FD5000"/>
        </a:solidFill>
        <a:effectLst/>
      </p:bgPr>
    </p:bg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4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72" name="Google Shape;72;p1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4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light green">
  <p:cSld name="b. left text and photo light green">
    <p:bg>
      <p:bgPr>
        <a:solidFill>
          <a:srgbClr val="78BF26"/>
        </a:solidFill>
        <a:effectLst/>
      </p:bgPr>
    </p:bg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77" name="Google Shape;77;p1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78" name="Google Shape;78;p15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purpl">
  <p:cSld name="b. left text and photo purpl">
    <p:bg>
      <p:bgPr>
        <a:solidFill>
          <a:srgbClr val="3C0032"/>
        </a:solidFill>
        <a:effectLst/>
      </p:bgPr>
    </p:bg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p16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81" name="Google Shape;81;p16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82" name="Google Shape;82;p1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83" name="Google Shape;83;p16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warm grey">
  <p:cSld name="b. left text and photo warm grey">
    <p:bg>
      <p:bgPr>
        <a:solidFill>
          <a:srgbClr val="A6A091"/>
        </a:solidFill>
        <a:effectLst/>
      </p:bgPr>
    </p:bg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7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86" name="Google Shape;86;p17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87" name="Google Shape;87;p17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Google Shape;88;p17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. left text and photo light grey">
  <p:cSld name="b. left text and photo light grey">
    <p:bg>
      <p:bgPr>
        <a:solidFill>
          <a:srgbClr val="E6E4DB"/>
        </a:solidFill>
        <a:effectLst/>
      </p:bgPr>
    </p:bg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18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91" name="Google Shape;91;p18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92" name="Google Shape;92;p18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p18"/>
          <p:cNvSpPr>
            <a:spLocks noGrp="1"/>
          </p:cNvSpPr>
          <p:nvPr>
            <p:ph type="pic" idx="2"/>
          </p:nvPr>
        </p:nvSpPr>
        <p:spPr>
          <a:xfrm>
            <a:off x="7606700" y="1831433"/>
            <a:ext cx="4169600" cy="4694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light grey">
  <p:cSld name="e. right text and full height photo light grey">
    <p:bg>
      <p:bgPr>
        <a:solidFill>
          <a:srgbClr val="E6E4DB"/>
        </a:solidFill>
        <a:effectLst/>
      </p:bgPr>
    </p:bg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19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96" name="Google Shape;96;p19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97" name="Google Shape;97;p19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98" name="Google Shape;98;p1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yellow">
  <p:cSld name="e. right text and full height photo yellow">
    <p:bg>
      <p:bgPr>
        <a:solidFill>
          <a:srgbClr val="FFD200"/>
        </a:solidFill>
        <a:effectLst/>
      </p:bgPr>
    </p:bg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20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01" name="Google Shape;101;p20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02" name="Google Shape;102;p20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03" name="Google Shape;103;p2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orange">
  <p:cSld name="e. right text and full height photo orange">
    <p:bg>
      <p:bgPr>
        <a:solidFill>
          <a:srgbClr val="FD5000"/>
        </a:solidFill>
        <a:effectLst/>
      </p:bgPr>
    </p:bg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21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06" name="Google Shape;106;p21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07" name="Google Shape;107;p21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08" name="Google Shape;108;p2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dark blue">
  <p:cSld name="a. title slide dark blue">
    <p:bg>
      <p:bgPr>
        <a:solidFill>
          <a:srgbClr val="001E82"/>
        </a:solidFill>
        <a:effectLst/>
      </p:bgPr>
    </p:bg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4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900"/>
              <a:buNone/>
              <a:defRPr sz="7866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83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50"/>
              <a:buFont typeface="Inter"/>
              <a:buNone/>
              <a:defRPr sz="1667" b="0">
                <a:solidFill>
                  <a:schemeClr val="lt1"/>
                </a:solidFill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22" name="Google Shape;22;p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1" y="100801"/>
            <a:ext cx="2260801" cy="22608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warm grey">
  <p:cSld name="e. right text and full height photo warm grey">
    <p:bg>
      <p:bgPr>
        <a:solidFill>
          <a:srgbClr val="A6A091"/>
        </a:solidFill>
        <a:effectLst/>
      </p:bgPr>
    </p:bg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22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11" name="Google Shape;111;p22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12" name="Google Shape;112;p22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13" name="Google Shape;113;p2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light green">
  <p:cSld name="e. right text and full height photo light green">
    <p:bg>
      <p:bgPr>
        <a:solidFill>
          <a:srgbClr val="78BF26"/>
        </a:solidFill>
        <a:effectLst/>
      </p:bgPr>
    </p:bg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3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16" name="Google Shape;116;p23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17" name="Google Shape;117;p23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18" name="Google Shape;118;p2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purple">
  <p:cSld name="e. right text and full height photo purple">
    <p:bg>
      <p:bgPr>
        <a:solidFill>
          <a:srgbClr val="3C0032"/>
        </a:solidFill>
        <a:effectLst/>
      </p:bgPr>
    </p:bg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24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21" name="Google Shape;121;p24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22" name="Google Shape;122;p24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23" name="Google Shape;123;p2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dark green">
  <p:cSld name="e. right text and full height photo dark green">
    <p:bg>
      <p:bgPr>
        <a:solidFill>
          <a:srgbClr val="144835"/>
        </a:solidFill>
        <a:effectLst/>
      </p:bgPr>
    </p:bg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25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26" name="Google Shape;126;p25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27" name="Google Shape;127;p25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28" name="Google Shape;128;p2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. right text and full height photo dark blue">
  <p:cSld name="e. right text and full height photo dark blue">
    <p:bg>
      <p:bgPr>
        <a:solidFill>
          <a:srgbClr val="001E82"/>
        </a:solidFill>
        <a:effectLst/>
      </p:bgPr>
    </p:bg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26"/>
          <p:cNvSpPr>
            <a:spLocks noGrp="1"/>
          </p:cNvSpPr>
          <p:nvPr>
            <p:ph type="pic" idx="2"/>
          </p:nvPr>
        </p:nvSpPr>
        <p:spPr>
          <a:xfrm>
            <a:off x="-717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31" name="Google Shape;131;p26"/>
          <p:cNvSpPr txBox="1">
            <a:spLocks noGrp="1"/>
          </p:cNvSpPr>
          <p:nvPr>
            <p:ph type="body" idx="1"/>
          </p:nvPr>
        </p:nvSpPr>
        <p:spPr>
          <a:xfrm>
            <a:off x="6049700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32" name="Google Shape;132;p26"/>
          <p:cNvSpPr txBox="1">
            <a:spLocks noGrp="1"/>
          </p:cNvSpPr>
          <p:nvPr>
            <p:ph type="title"/>
          </p:nvPr>
        </p:nvSpPr>
        <p:spPr>
          <a:xfrm>
            <a:off x="5867100" y="18804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33" name="Google Shape;133;p2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light grey">
  <p:cSld name="d. left text and full height photo light grey">
    <p:bg>
      <p:bgPr>
        <a:solidFill>
          <a:srgbClr val="E6E4DB"/>
        </a:solidFill>
        <a:effectLst/>
      </p:bgPr>
    </p:bg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27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136" name="Google Shape;136;p27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37" name="Google Shape;137;p27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yellow">
  <p:cSld name="d. left text and full height photo yellow">
    <p:bg>
      <p:bgPr>
        <a:solidFill>
          <a:srgbClr val="FFD200"/>
        </a:solidFill>
        <a:effectLst/>
      </p:bgPr>
    </p:bg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28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40" name="Google Shape;140;p28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41" name="Google Shape;141;p28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orange">
  <p:cSld name="d. left text and full height photo orange">
    <p:bg>
      <p:bgPr>
        <a:solidFill>
          <a:srgbClr val="FD5000"/>
        </a:solidFill>
        <a:effectLst/>
      </p:bgPr>
    </p:bg>
    <p:spTree>
      <p:nvGrpSpPr>
        <p:cNvPr id="1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Google Shape;143;p29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44" name="Google Shape;144;p29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45" name="Google Shape;145;p29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light green">
  <p:cSld name="d. left text and full height photo light green">
    <p:bg>
      <p:bgPr>
        <a:solidFill>
          <a:srgbClr val="78BF26"/>
        </a:solidFill>
        <a:effectLst/>
      </p:bgPr>
    </p:bg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30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48" name="Google Shape;148;p30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49" name="Google Shape;149;p30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warm grey">
  <p:cSld name="d. left text and full height photo warm grey">
    <p:bg>
      <p:bgPr>
        <a:solidFill>
          <a:srgbClr val="A6A091"/>
        </a:solidFill>
        <a:effectLst/>
      </p:bgPr>
    </p:bg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Google Shape;151;p31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52" name="Google Shape;152;p31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53" name="Google Shape;153;p31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light green">
  <p:cSld name="a. title slide light green">
    <p:bg>
      <p:bgPr>
        <a:solidFill>
          <a:srgbClr val="78BF26"/>
        </a:solidFill>
        <a:effectLst/>
      </p:bgPr>
    </p:bg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5900"/>
              <a:buNone/>
              <a:defRPr sz="7866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89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50"/>
              <a:buFont typeface="Inter"/>
              <a:buNone/>
              <a:defRPr sz="1667" b="0"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27" name="Google Shape;27;p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0" y="100800"/>
            <a:ext cx="2258835" cy="225883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dark blue">
  <p:cSld name="d. left text and full height photo dark blue">
    <p:bg>
      <p:bgPr>
        <a:solidFill>
          <a:srgbClr val="001E82"/>
        </a:solidFill>
        <a:effectLst/>
      </p:bgPr>
    </p:bg>
    <p:spTree>
      <p:nvGrpSpPr>
        <p:cNvPr id="1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Google Shape;155;p32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56" name="Google Shape;156;p32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57" name="Google Shape;157;p32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dark green">
  <p:cSld name="d. left text and full height photo dark green">
    <p:bg>
      <p:bgPr>
        <a:solidFill>
          <a:srgbClr val="144835"/>
        </a:solidFill>
        <a:effectLst/>
      </p:bgPr>
    </p:bg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33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60" name="Google Shape;160;p33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61" name="Google Shape;161;p33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. left text and full height photo purple">
  <p:cSld name="d. left text and full height photo purple">
    <p:bg>
      <p:bgPr>
        <a:solidFill>
          <a:srgbClr val="3C0032"/>
        </a:solidFill>
        <a:effectLst/>
      </p:bgPr>
    </p:bg>
    <p:spTree>
      <p:nvGrpSpPr>
        <p:cNvPr id="1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Google Shape;163;p34"/>
          <p:cNvSpPr>
            <a:spLocks noGrp="1"/>
          </p:cNvSpPr>
          <p:nvPr>
            <p:ph type="pic" idx="2"/>
          </p:nvPr>
        </p:nvSpPr>
        <p:spPr>
          <a:xfrm>
            <a:off x="6902500" y="0"/>
            <a:ext cx="6140000" cy="68580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64" name="Google Shape;164;p34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65" name="Google Shape;165;p34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dark blue">
  <p:cSld name="c. right text and photo dark blue">
    <p:bg>
      <p:bgPr>
        <a:solidFill>
          <a:srgbClr val="001E82"/>
        </a:solidFill>
        <a:effectLst/>
      </p:bgPr>
    </p:bg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35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168" name="Google Shape;168;p35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69" name="Google Shape;169;p35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pic>
        <p:nvPicPr>
          <p:cNvPr id="170" name="Google Shape;170;p3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dark green">
  <p:cSld name="c. right text and photo dark green">
    <p:bg>
      <p:bgPr>
        <a:solidFill>
          <a:srgbClr val="144835"/>
        </a:solidFill>
        <a:effectLst/>
      </p:bgPr>
    </p:bg>
    <p:spTree>
      <p:nvGrpSpPr>
        <p:cNvPr id="1" name="Shape 1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Google Shape;172;p36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73" name="Google Shape;173;p36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74" name="Google Shape;174;p36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75" name="Google Shape;175;p3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light green">
  <p:cSld name="c. right text and photo light green">
    <p:bg>
      <p:bgPr>
        <a:solidFill>
          <a:srgbClr val="78BF26"/>
        </a:solidFill>
        <a:effectLst/>
      </p:bgPr>
    </p:bg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37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78" name="Google Shape;178;p37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79" name="Google Shape;179;p37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80" name="Google Shape;180;p37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orange">
  <p:cSld name="c. right text and photo orange">
    <p:bg>
      <p:bgPr>
        <a:solidFill>
          <a:srgbClr val="FD5000"/>
        </a:solidFill>
        <a:effectLst/>
      </p:bgPr>
    </p:bg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38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83" name="Google Shape;183;p38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84" name="Google Shape;184;p38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85" name="Google Shape;185;p38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yellow">
  <p:cSld name="c. right text and photo yellow">
    <p:bg>
      <p:bgPr>
        <a:solidFill>
          <a:srgbClr val="FFD200"/>
        </a:solidFill>
        <a:effectLst/>
      </p:bgPr>
    </p:bg>
    <p:spTree>
      <p:nvGrpSpPr>
        <p:cNvPr id="1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39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88" name="Google Shape;188;p39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89" name="Google Shape;189;p39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90" name="Google Shape;190;p3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purple">
  <p:cSld name="c. right text and photo purple">
    <p:bg>
      <p:bgPr>
        <a:solidFill>
          <a:srgbClr val="3C0032"/>
        </a:solidFill>
        <a:effectLst/>
      </p:bgPr>
    </p:bg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40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93" name="Google Shape;193;p40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94" name="Google Shape;194;p40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195" name="Google Shape;195;p4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warm grey">
  <p:cSld name="c. right text and photo warm grey">
    <p:bg>
      <p:bgPr>
        <a:solidFill>
          <a:srgbClr val="A6A091"/>
        </a:solidFill>
        <a:effectLst/>
      </p:bgPr>
    </p:bg>
    <p:spTree>
      <p:nvGrpSpPr>
        <p:cNvPr id="1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41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198" name="Google Shape;198;p41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199" name="Google Shape;199;p41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00" name="Google Shape;200;p4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dark green">
  <p:cSld name="a. title slide dark green">
    <p:bg>
      <p:bgPr>
        <a:solidFill>
          <a:srgbClr val="144835"/>
        </a:solidFill>
        <a:effectLst/>
      </p:bgPr>
    </p:bg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6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900"/>
              <a:buNone/>
              <a:defRPr sz="7866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30" name="Google Shape;30;p6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83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50"/>
              <a:buFont typeface="Inter"/>
              <a:buNone/>
              <a:defRPr sz="1667" b="0">
                <a:solidFill>
                  <a:schemeClr val="lt1"/>
                </a:solidFill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32" name="Google Shape;32;p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1" y="100801"/>
            <a:ext cx="2260801" cy="22608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. right text and photo light grey">
  <p:cSld name="c. right text and photo light grey">
    <p:bg>
      <p:bgPr>
        <a:solidFill>
          <a:srgbClr val="E6E4DB"/>
        </a:solidFill>
        <a:effectLst/>
      </p:bgPr>
    </p:bg>
    <p:spTree>
      <p:nvGrpSpPr>
        <p:cNvPr id="1" name="Shape 2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Google Shape;202;p42"/>
          <p:cNvSpPr>
            <a:spLocks noGrp="1"/>
          </p:cNvSpPr>
          <p:nvPr>
            <p:ph type="pic" idx="2"/>
          </p:nvPr>
        </p:nvSpPr>
        <p:spPr>
          <a:xfrm>
            <a:off x="436267" y="457500"/>
            <a:ext cx="4394400" cy="6118800"/>
          </a:xfrm>
          <a:prstGeom prst="roundRect">
            <a:avLst>
              <a:gd name="adj" fmla="val 13323"/>
            </a:avLst>
          </a:prstGeom>
          <a:noFill/>
          <a:ln>
            <a:noFill/>
          </a:ln>
        </p:spPr>
      </p:sp>
      <p:sp>
        <p:nvSpPr>
          <p:cNvPr id="203" name="Google Shape;203;p42"/>
          <p:cNvSpPr txBox="1">
            <a:spLocks noGrp="1"/>
          </p:cNvSpPr>
          <p:nvPr>
            <p:ph type="body" idx="1"/>
          </p:nvPr>
        </p:nvSpPr>
        <p:spPr>
          <a:xfrm>
            <a:off x="5301167" y="35256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04" name="Google Shape;204;p42"/>
          <p:cNvSpPr txBox="1">
            <a:spLocks noGrp="1"/>
          </p:cNvSpPr>
          <p:nvPr>
            <p:ph type="title"/>
          </p:nvPr>
        </p:nvSpPr>
        <p:spPr>
          <a:xfrm>
            <a:off x="5301167" y="1961800"/>
            <a:ext cx="6314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05" name="Google Shape;205;p4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light green">
  <p:cSld name="f. left text and multi image light green">
    <p:bg>
      <p:bgPr>
        <a:solidFill>
          <a:srgbClr val="78BF26"/>
        </a:solidFill>
        <a:effectLst/>
      </p:bgPr>
    </p:bg>
    <p:spTree>
      <p:nvGrpSpPr>
        <p:cNvPr id="1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43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08" name="Google Shape;208;p43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09" name="Google Shape;209;p43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10" name="Google Shape;210;p43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211" name="Google Shape;211;p43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2000"/>
              <a:buChar char="●"/>
              <a:defRPr sz="2667"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pic>
        <p:nvPicPr>
          <p:cNvPr id="212" name="Google Shape;212;p4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orange">
  <p:cSld name="f. left text and multi image orange">
    <p:bg>
      <p:bgPr>
        <a:solidFill>
          <a:srgbClr val="FD5000"/>
        </a:solidFill>
        <a:effectLst/>
      </p:bgPr>
    </p:bg>
    <p:spTree>
      <p:nvGrpSpPr>
        <p:cNvPr id="1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44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2000"/>
              <a:buChar char="●"/>
              <a:defRPr sz="2667"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15" name="Google Shape;215;p44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16" name="Google Shape;216;p4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17" name="Google Shape;217;p44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18" name="Google Shape;218;p44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19" name="Google Shape;219;p44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yellow">
  <p:cSld name="f. left text and multi image yellow">
    <p:bg>
      <p:bgPr>
        <a:solidFill>
          <a:srgbClr val="FFD200"/>
        </a:solidFill>
        <a:effectLst/>
      </p:bgPr>
    </p:bg>
    <p:spTree>
      <p:nvGrpSpPr>
        <p:cNvPr id="1" name="Shape 2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Google Shape;221;p45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2000"/>
              <a:buChar char="●"/>
              <a:defRPr sz="2667"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22" name="Google Shape;222;p45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23" name="Google Shape;223;p4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24" name="Google Shape;224;p45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25" name="Google Shape;225;p45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26" name="Google Shape;226;p45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dark blue">
  <p:cSld name="f. left text and multi image dark blue">
    <p:bg>
      <p:bgPr>
        <a:solidFill>
          <a:srgbClr val="001E82"/>
        </a:solidFill>
        <a:effectLst/>
      </p:bgPr>
    </p:bg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46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229" name="Google Shape;229;p46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30" name="Google Shape;230;p4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231" name="Google Shape;231;p46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32" name="Google Shape;232;p46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33" name="Google Shape;233;p46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purple">
  <p:cSld name="f. left text and multi image purple">
    <p:bg>
      <p:bgPr>
        <a:solidFill>
          <a:srgbClr val="3C0032"/>
        </a:solidFill>
        <a:effectLst/>
      </p:bgPr>
    </p:bg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47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236" name="Google Shape;236;p47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37" name="Google Shape;237;p47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238" name="Google Shape;238;p47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39" name="Google Shape;239;p47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40" name="Google Shape;240;p47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dark green">
  <p:cSld name="f. left text and multi image dark green">
    <p:bg>
      <p:bgPr>
        <a:solidFill>
          <a:srgbClr val="144835"/>
        </a:solidFill>
        <a:effectLst/>
      </p:bgPr>
    </p:bg>
    <p:spTree>
      <p:nvGrpSpPr>
        <p:cNvPr id="1" name="Shape 2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Google Shape;242;p48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000"/>
              <a:buChar char="●"/>
              <a:defRPr sz="2667">
                <a:solidFill>
                  <a:schemeClr val="lt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●"/>
              <a:defRPr>
                <a:solidFill>
                  <a:schemeClr val="lt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○"/>
              <a:defRPr>
                <a:solidFill>
                  <a:schemeClr val="lt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Char char="■"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243" name="Google Shape;243;p48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44" name="Google Shape;244;p48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245" name="Google Shape;245;p48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46" name="Google Shape;246;p48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47" name="Google Shape;247;p48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warm grey">
  <p:cSld name="f. left text and multi image warm grey">
    <p:bg>
      <p:bgPr>
        <a:solidFill>
          <a:srgbClr val="A6A091"/>
        </a:solidFill>
        <a:effectLst/>
      </p:bgPr>
    </p:bg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49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2000"/>
              <a:buChar char="●"/>
              <a:defRPr sz="2667"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250" name="Google Shape;250;p49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251" name="Google Shape;251;p4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52" name="Google Shape;252;p49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53" name="Google Shape;253;p49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54" name="Google Shape;254;p49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. left text and multi image light grey">
  <p:cSld name="f. left text and multi image light grey">
    <p:bg>
      <p:bgPr>
        <a:solidFill>
          <a:srgbClr val="E6E4DB"/>
        </a:solidFill>
        <a:effectLst/>
      </p:bgPr>
    </p:bg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50"/>
          <p:cNvSpPr txBox="1">
            <a:spLocks noGrp="1"/>
          </p:cNvSpPr>
          <p:nvPr>
            <p:ph type="title"/>
          </p:nvPr>
        </p:nvSpPr>
        <p:spPr>
          <a:xfrm>
            <a:off x="766500" y="742600"/>
            <a:ext cx="58400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257" name="Google Shape;257;p50"/>
          <p:cNvSpPr txBox="1">
            <a:spLocks noGrp="1"/>
          </p:cNvSpPr>
          <p:nvPr>
            <p:ph type="body" idx="1"/>
          </p:nvPr>
        </p:nvSpPr>
        <p:spPr>
          <a:xfrm>
            <a:off x="766500" y="2611200"/>
            <a:ext cx="5949200" cy="332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2000"/>
              <a:buChar char="●"/>
              <a:defRPr sz="2667"/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pic>
        <p:nvPicPr>
          <p:cNvPr id="258" name="Google Shape;258;p5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59" name="Google Shape;259;p50"/>
          <p:cNvSpPr>
            <a:spLocks noGrp="1"/>
          </p:cNvSpPr>
          <p:nvPr>
            <p:ph type="pic" idx="2"/>
          </p:nvPr>
        </p:nvSpPr>
        <p:spPr>
          <a:xfrm>
            <a:off x="6383000" y="1874100"/>
            <a:ext cx="3892000" cy="22272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60" name="Google Shape;260;p50"/>
          <p:cNvSpPr>
            <a:spLocks noGrp="1"/>
          </p:cNvSpPr>
          <p:nvPr>
            <p:ph type="pic" idx="3"/>
          </p:nvPr>
        </p:nvSpPr>
        <p:spPr>
          <a:xfrm>
            <a:off x="9254551" y="3355100"/>
            <a:ext cx="3095600" cy="17716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61" name="Google Shape;261;p50"/>
          <p:cNvSpPr>
            <a:spLocks noGrp="1"/>
          </p:cNvSpPr>
          <p:nvPr>
            <p:ph type="pic" idx="4"/>
          </p:nvPr>
        </p:nvSpPr>
        <p:spPr>
          <a:xfrm>
            <a:off x="8350665" y="4824533"/>
            <a:ext cx="29532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</p:spTree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light grey">
  <p:cSld name="g. photo and text columns light grey">
    <p:bg>
      <p:bgPr>
        <a:solidFill>
          <a:srgbClr val="E6E4DB"/>
        </a:solidFill>
        <a:effectLst/>
      </p:bgPr>
    </p:bg>
    <p:spTree>
      <p:nvGrpSpPr>
        <p:cNvPr id="1" name="Shape 2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Google Shape;263;p51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64" name="Google Shape;264;p51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65" name="Google Shape;265;p51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66" name="Google Shape;266;p51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67" name="Google Shape;267;p51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68" name="Google Shape;268;p51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69" name="Google Shape;269;p51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70" name="Google Shape;270;p51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71" name="Google Shape;271;p51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pic>
        <p:nvPicPr>
          <p:cNvPr id="272" name="Google Shape;272;p5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orange">
  <p:cSld name="a. title slide orange">
    <p:bg>
      <p:bgPr>
        <a:solidFill>
          <a:srgbClr val="FD5000"/>
        </a:solidFill>
        <a:effectLst/>
      </p:bgPr>
    </p:bg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5900"/>
              <a:buNone/>
              <a:defRPr sz="7866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36" name="Google Shape;36;p7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89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50"/>
              <a:buFont typeface="Inter"/>
              <a:buNone/>
              <a:defRPr sz="1667" b="0"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37" name="Google Shape;37;p7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0" y="100800"/>
            <a:ext cx="2258835" cy="225883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warm grey">
  <p:cSld name="g. photo and text columns warm grey">
    <p:bg>
      <p:bgPr>
        <a:solidFill>
          <a:srgbClr val="A6A091"/>
        </a:solidFill>
        <a:effectLst/>
      </p:bgPr>
    </p:bg>
    <p:spTree>
      <p:nvGrpSpPr>
        <p:cNvPr id="1" name="Shape 2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4" name="Google Shape;274;p5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75" name="Google Shape;275;p52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76" name="Google Shape;276;p52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77" name="Google Shape;277;p52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78" name="Google Shape;278;p52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79" name="Google Shape;279;p52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80" name="Google Shape;280;p52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81" name="Google Shape;281;p52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82" name="Google Shape;282;p52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83" name="Google Shape;283;p52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orange">
  <p:cSld name="g. photo and text columns orange">
    <p:bg>
      <p:bgPr>
        <a:solidFill>
          <a:srgbClr val="FD5000"/>
        </a:solidFill>
        <a:effectLst/>
      </p:bgPr>
    </p:bg>
    <p:spTree>
      <p:nvGrpSpPr>
        <p:cNvPr id="1" name="Shape 2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5" name="Google Shape;285;p5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86" name="Google Shape;286;p53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87" name="Google Shape;287;p53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88" name="Google Shape;288;p53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89" name="Google Shape;289;p53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90" name="Google Shape;290;p53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91" name="Google Shape;291;p53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92" name="Google Shape;292;p53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93" name="Google Shape;293;p53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294" name="Google Shape;294;p53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light green">
  <p:cSld name="g. photo and text columns light green">
    <p:bg>
      <p:bgPr>
        <a:solidFill>
          <a:srgbClr val="78BF26"/>
        </a:solidFill>
        <a:effectLst/>
      </p:bgPr>
    </p:bg>
    <p:spTree>
      <p:nvGrpSpPr>
        <p:cNvPr id="1" name="Shape 2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" name="Google Shape;296;p5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297" name="Google Shape;297;p54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298" name="Google Shape;298;p54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299" name="Google Shape;299;p54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00" name="Google Shape;300;p54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01" name="Google Shape;301;p54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302" name="Google Shape;302;p54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303" name="Google Shape;303;p54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304" name="Google Shape;304;p54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305" name="Google Shape;305;p54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yellow">
  <p:cSld name="g. photo and text columns yellow">
    <p:bg>
      <p:bgPr>
        <a:solidFill>
          <a:srgbClr val="FFD200"/>
        </a:solidFill>
        <a:effectLst/>
      </p:bgPr>
    </p:bg>
    <p:spTree>
      <p:nvGrpSpPr>
        <p:cNvPr id="1" name="Shape 3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" name="Google Shape;307;p5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  <p:sp>
        <p:nvSpPr>
          <p:cNvPr id="308" name="Google Shape;308;p55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09" name="Google Shape;309;p55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310" name="Google Shape;310;p55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11" name="Google Shape;311;p55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12" name="Google Shape;312;p55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313" name="Google Shape;313;p55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20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  <a:defRPr sz="1600">
                <a:solidFill>
                  <a:schemeClr val="dk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○"/>
              <a:defRPr sz="1600">
                <a:solidFill>
                  <a:schemeClr val="dk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■"/>
              <a:defRPr sz="16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314" name="Google Shape;314;p55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315" name="Google Shape;315;p55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316" name="Google Shape;316;p55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Inter SemiBold"/>
              <a:buNone/>
              <a:defRPr sz="2133">
                <a:solidFill>
                  <a:srgbClr val="000000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dark blue">
  <p:cSld name="g. photo and text columns dark blue">
    <p:bg>
      <p:bgPr>
        <a:solidFill>
          <a:srgbClr val="001E82"/>
        </a:solidFill>
        <a:effectLst/>
      </p:bgPr>
    </p:bg>
    <p:spTree>
      <p:nvGrpSpPr>
        <p:cNvPr id="1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56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19" name="Google Shape;319;p56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20" name="Google Shape;320;p56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21" name="Google Shape;321;p56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22" name="Google Shape;322;p56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23" name="Google Shape;323;p56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24" name="Google Shape;324;p56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25" name="Google Shape;325;p56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26" name="Google Shape;326;p56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327" name="Google Shape;327;p5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purple">
  <p:cSld name="g. photo and text columns purple">
    <p:bg>
      <p:bgPr>
        <a:solidFill>
          <a:srgbClr val="3C0032"/>
        </a:solidFill>
        <a:effectLst/>
      </p:bgPr>
    </p:bg>
    <p:spTree>
      <p:nvGrpSpPr>
        <p:cNvPr id="1" name="Shape 3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9" name="Google Shape;329;p57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330" name="Google Shape;330;p57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31" name="Google Shape;331;p57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32" name="Google Shape;332;p57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33" name="Google Shape;333;p57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34" name="Google Shape;334;p57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35" name="Google Shape;335;p57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36" name="Google Shape;336;p57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37" name="Google Shape;337;p57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38" name="Google Shape;338;p57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g. photo and text columns dark green">
  <p:cSld name="g. photo and text columns dark green">
    <p:bg>
      <p:bgPr>
        <a:solidFill>
          <a:srgbClr val="144835"/>
        </a:solidFill>
        <a:effectLst/>
      </p:bgPr>
    </p:bg>
    <p:spTree>
      <p:nvGrpSpPr>
        <p:cNvPr id="1" name="Shape 3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0" name="Google Shape;340;p58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  <p:sp>
        <p:nvSpPr>
          <p:cNvPr id="341" name="Google Shape;341;p58"/>
          <p:cNvSpPr>
            <a:spLocks noGrp="1"/>
          </p:cNvSpPr>
          <p:nvPr>
            <p:ph type="pic" idx="2"/>
          </p:nvPr>
        </p:nvSpPr>
        <p:spPr>
          <a:xfrm>
            <a:off x="386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42" name="Google Shape;342;p58"/>
          <p:cNvSpPr txBox="1">
            <a:spLocks noGrp="1"/>
          </p:cNvSpPr>
          <p:nvPr>
            <p:ph type="body" idx="1"/>
          </p:nvPr>
        </p:nvSpPr>
        <p:spPr>
          <a:xfrm>
            <a:off x="386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43" name="Google Shape;343;p58"/>
          <p:cNvSpPr>
            <a:spLocks noGrp="1"/>
          </p:cNvSpPr>
          <p:nvPr>
            <p:ph type="pic" idx="3"/>
          </p:nvPr>
        </p:nvSpPr>
        <p:spPr>
          <a:xfrm>
            <a:off x="4305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44" name="Google Shape;344;p58"/>
          <p:cNvSpPr>
            <a:spLocks noGrp="1"/>
          </p:cNvSpPr>
          <p:nvPr>
            <p:ph type="pic" idx="4"/>
          </p:nvPr>
        </p:nvSpPr>
        <p:spPr>
          <a:xfrm>
            <a:off x="8224000" y="1974667"/>
            <a:ext cx="3582000" cy="1690000"/>
          </a:xfrm>
          <a:prstGeom prst="roundRect">
            <a:avLst>
              <a:gd name="adj" fmla="val 12371"/>
            </a:avLst>
          </a:prstGeom>
          <a:noFill/>
          <a:ln>
            <a:noFill/>
          </a:ln>
        </p:spPr>
      </p:sp>
      <p:sp>
        <p:nvSpPr>
          <p:cNvPr id="345" name="Google Shape;345;p58"/>
          <p:cNvSpPr txBox="1">
            <a:spLocks noGrp="1"/>
          </p:cNvSpPr>
          <p:nvPr>
            <p:ph type="body" idx="5"/>
          </p:nvPr>
        </p:nvSpPr>
        <p:spPr>
          <a:xfrm>
            <a:off x="4305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46" name="Google Shape;346;p58"/>
          <p:cNvSpPr txBox="1">
            <a:spLocks noGrp="1"/>
          </p:cNvSpPr>
          <p:nvPr>
            <p:ph type="body" idx="6"/>
          </p:nvPr>
        </p:nvSpPr>
        <p:spPr>
          <a:xfrm>
            <a:off x="8224000" y="4830667"/>
            <a:ext cx="3582000" cy="19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91425" rIns="91425" bIns="91425" anchor="t" anchorCtr="0">
            <a:noAutofit/>
          </a:bodyPr>
          <a:lstStyle>
            <a:lvl1pPr marL="457200" lvl="0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1pPr>
            <a:lvl2pPr marL="914400" lvl="1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2pPr>
            <a:lvl3pPr marL="1371600" lvl="2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3pPr>
            <a:lvl4pPr marL="1828800" lvl="3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4pPr>
            <a:lvl5pPr marL="2286000" lvl="4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5pPr>
            <a:lvl6pPr marL="2743200" lvl="5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6pPr>
            <a:lvl7pPr marL="3200400" lvl="6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●"/>
              <a:defRPr sz="1600">
                <a:solidFill>
                  <a:schemeClr val="lt1"/>
                </a:solidFill>
              </a:defRPr>
            </a:lvl7pPr>
            <a:lvl8pPr marL="3657600" lvl="7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○"/>
              <a:defRPr sz="1600">
                <a:solidFill>
                  <a:schemeClr val="lt1"/>
                </a:solidFill>
              </a:defRPr>
            </a:lvl8pPr>
            <a:lvl9pPr marL="4114800" lvl="8" indent="-30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"/>
              <a:buChar char="■"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47" name="Google Shape;347;p58"/>
          <p:cNvSpPr txBox="1">
            <a:spLocks noGrp="1"/>
          </p:cNvSpPr>
          <p:nvPr>
            <p:ph type="subTitle" idx="7"/>
          </p:nvPr>
        </p:nvSpPr>
        <p:spPr>
          <a:xfrm>
            <a:off x="386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48" name="Google Shape;348;p58"/>
          <p:cNvSpPr txBox="1">
            <a:spLocks noGrp="1"/>
          </p:cNvSpPr>
          <p:nvPr>
            <p:ph type="subTitle" idx="8"/>
          </p:nvPr>
        </p:nvSpPr>
        <p:spPr>
          <a:xfrm>
            <a:off x="4305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49" name="Google Shape;349;p58"/>
          <p:cNvSpPr txBox="1">
            <a:spLocks noGrp="1"/>
          </p:cNvSpPr>
          <p:nvPr>
            <p:ph type="subTitle" idx="9"/>
          </p:nvPr>
        </p:nvSpPr>
        <p:spPr>
          <a:xfrm>
            <a:off x="8224000" y="3913533"/>
            <a:ext cx="3582000" cy="96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Font typeface="Inter SemiBold"/>
              <a:buNone/>
              <a:defRPr sz="2133">
                <a:solidFill>
                  <a:schemeClr val="lt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Hind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light green">
  <p:cSld name="j. section title light green">
    <p:bg>
      <p:bgPr>
        <a:solidFill>
          <a:srgbClr val="78BF26"/>
        </a:solidFill>
        <a:effectLst/>
      </p:bgPr>
    </p:bg>
    <p:spTree>
      <p:nvGrpSpPr>
        <p:cNvPr id="1" name="Shape 3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Google Shape;351;p59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pic>
        <p:nvPicPr>
          <p:cNvPr id="352" name="Google Shape;352;p5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warm grey">
  <p:cSld name="j. section title warm grey">
    <p:bg>
      <p:bgPr>
        <a:solidFill>
          <a:srgbClr val="A6A091"/>
        </a:solidFill>
        <a:effectLst/>
      </p:bgPr>
    </p:bg>
    <p:spTree>
      <p:nvGrpSpPr>
        <p:cNvPr id="1" name="Shape 3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Google Shape;354;p60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pic>
        <p:nvPicPr>
          <p:cNvPr id="355" name="Google Shape;355;p6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light grey">
  <p:cSld name="j. section title light grey">
    <p:bg>
      <p:bgPr>
        <a:solidFill>
          <a:srgbClr val="E6E4DB"/>
        </a:solidFill>
        <a:effectLst/>
      </p:bgPr>
    </p:bg>
    <p:spTree>
      <p:nvGrpSpPr>
        <p:cNvPr id="1" name="Shape 3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Google Shape;357;p61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pic>
        <p:nvPicPr>
          <p:cNvPr id="358" name="Google Shape;358;p6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yellow">
  <p:cSld name="a. title slide yellow">
    <p:bg>
      <p:bgPr>
        <a:solidFill>
          <a:srgbClr val="FFD200"/>
        </a:solidFill>
        <a:effectLst/>
      </p:bgPr>
    </p:bg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8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5900"/>
              <a:buNone/>
              <a:defRPr sz="7866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93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50"/>
              <a:buFont typeface="Inter"/>
              <a:buNone/>
              <a:defRPr sz="1667" b="0"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42" name="Google Shape;42;p8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0" y="100800"/>
            <a:ext cx="2258835" cy="225883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yellow">
  <p:cSld name="j. section title yellow">
    <p:bg>
      <p:bgPr>
        <a:solidFill>
          <a:srgbClr val="FFD200"/>
        </a:solidFill>
        <a:effectLst/>
      </p:bgPr>
    </p:bg>
    <p:spTree>
      <p:nvGrpSpPr>
        <p:cNvPr id="1" name="Shape 3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Google Shape;360;p62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pic>
        <p:nvPicPr>
          <p:cNvPr id="361" name="Google Shape;361;p6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orange">
  <p:cSld name="j. section title orange">
    <p:bg>
      <p:bgPr>
        <a:solidFill>
          <a:srgbClr val="FD5000"/>
        </a:solidFill>
        <a:effectLst/>
      </p:bgPr>
    </p:bg>
    <p:spTree>
      <p:nvGrpSpPr>
        <p:cNvPr id="1" name="Shape 3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Google Shape;363;p63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  <a:defRPr sz="5467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pic>
        <p:nvPicPr>
          <p:cNvPr id="364" name="Google Shape;364;p6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300" y="100800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purple">
  <p:cSld name="j. section title purple">
    <p:bg>
      <p:bgPr>
        <a:solidFill>
          <a:srgbClr val="3C0032"/>
        </a:solidFill>
        <a:effectLst/>
      </p:bgPr>
    </p:bg>
    <p:spTree>
      <p:nvGrpSpPr>
        <p:cNvPr id="1" name="Shape 3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Google Shape;366;p64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pic>
        <p:nvPicPr>
          <p:cNvPr id="367" name="Google Shape;367;p6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dark green">
  <p:cSld name="j. section title dark green">
    <p:bg>
      <p:bgPr>
        <a:solidFill>
          <a:srgbClr val="144835"/>
        </a:solidFill>
        <a:effectLst/>
      </p:bgPr>
    </p:bg>
    <p:spTree>
      <p:nvGrpSpPr>
        <p:cNvPr id="1" name="Shape 3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Google Shape;369;p65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pic>
        <p:nvPicPr>
          <p:cNvPr id="370" name="Google Shape;370;p6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j. section title dark blue">
  <p:cSld name="j. section title dark blue">
    <p:bg>
      <p:bgPr>
        <a:solidFill>
          <a:srgbClr val="001E82"/>
        </a:solidFill>
        <a:effectLst/>
      </p:bgPr>
    </p:bg>
    <p:spTree>
      <p:nvGrpSpPr>
        <p:cNvPr id="1" name="Shape 3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Google Shape;372;p66"/>
          <p:cNvSpPr txBox="1">
            <a:spLocks noGrp="1"/>
          </p:cNvSpPr>
          <p:nvPr>
            <p:ph type="ctrTitle"/>
          </p:nvPr>
        </p:nvSpPr>
        <p:spPr>
          <a:xfrm>
            <a:off x="415611" y="2608767"/>
            <a:ext cx="11360800" cy="273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100"/>
              <a:buNone/>
              <a:defRPr sz="5467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200"/>
              <a:buNone/>
              <a:defRPr sz="6933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pic>
        <p:nvPicPr>
          <p:cNvPr id="373" name="Google Shape;373;p6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orange">
  <p:cSld name="k. key facts orang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3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Google Shape;375;p67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D5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6" name="Google Shape;376;p67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D5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7" name="Google Shape;377;p67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D5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8" name="Google Shape;378;p67"/>
          <p:cNvSpPr txBox="1">
            <a:spLocks noGrp="1"/>
          </p:cNvSpPr>
          <p:nvPr>
            <p:ph type="subTitle" idx="1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79" name="Google Shape;379;p67"/>
          <p:cNvSpPr txBox="1">
            <a:spLocks noGrp="1"/>
          </p:cNvSpPr>
          <p:nvPr>
            <p:ph type="subTitle" idx="2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80" name="Google Shape;380;p67"/>
          <p:cNvSpPr txBox="1">
            <a:spLocks noGrp="1"/>
          </p:cNvSpPr>
          <p:nvPr>
            <p:ph type="subTitle" idx="3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381" name="Google Shape;381;p67"/>
          <p:cNvSpPr txBox="1">
            <a:spLocks noGrp="1"/>
          </p:cNvSpPr>
          <p:nvPr>
            <p:ph type="subTitle" idx="4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382" name="Google Shape;382;p67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83" name="Google Shape;383;p67"/>
          <p:cNvSpPr txBox="1">
            <a:spLocks noGrp="1"/>
          </p:cNvSpPr>
          <p:nvPr>
            <p:ph type="subTitle" idx="5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384" name="Google Shape;384;p67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85" name="Google Shape;385;p67"/>
          <p:cNvSpPr txBox="1">
            <a:spLocks noGrp="1"/>
          </p:cNvSpPr>
          <p:nvPr>
            <p:ph type="subTitle" idx="6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386" name="Google Shape;386;p67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87" name="Google Shape;387;p67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388" name="Google Shape;388;p67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389" name="Google Shape;389;p67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390" name="Google Shape;390;p67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pic>
        <p:nvPicPr>
          <p:cNvPr id="391" name="Google Shape;391;p6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yellow">
  <p:cSld name="k. key facts yellow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3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Google Shape;393;p68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FD2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4" name="Google Shape;394;p68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FD2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5" name="Google Shape;395;p68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FFD2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6" name="Google Shape;396;p68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397" name="Google Shape;397;p68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398" name="Google Shape;398;p68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399" name="Google Shape;399;p68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00" name="Google Shape;400;p68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01" name="Google Shape;401;p68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02" name="Google Shape;402;p68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sp>
        <p:nvSpPr>
          <p:cNvPr id="403" name="Google Shape;403;p68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04" name="Google Shape;404;p68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05" name="Google Shape;405;p68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06" name="Google Shape;406;p68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07" name="Google Shape;407;p68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08" name="Google Shape;408;p68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pic>
        <p:nvPicPr>
          <p:cNvPr id="409" name="Google Shape;409;p6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warm grey">
  <p:cSld name="k. key facts warm grey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4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Google Shape;411;p69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A6A09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12" name="Google Shape;412;p69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A6A09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13" name="Google Shape;413;p69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A6A09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14" name="Google Shape;414;p69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15" name="Google Shape;415;p69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16" name="Google Shape;416;p69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17" name="Google Shape;417;p69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18" name="Google Shape;418;p69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19" name="Google Shape;419;p69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20" name="Google Shape;420;p69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21" name="Google Shape;421;p69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22" name="Google Shape;422;p69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23" name="Google Shape;423;p69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24" name="Google Shape;424;p69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25" name="Google Shape;425;p69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26" name="Google Shape;426;p69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427" name="Google Shape;427;p6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dark blue">
  <p:cSld name="k. key facts dark blu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4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Google Shape;429;p70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001E8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0" name="Google Shape;430;p70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001E8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1" name="Google Shape;431;p70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001E8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2" name="Google Shape;432;p70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33" name="Google Shape;433;p70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34" name="Google Shape;434;p70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35" name="Google Shape;435;p70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36" name="Google Shape;436;p70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37" name="Google Shape;437;p70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38" name="Google Shape;438;p70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39" name="Google Shape;439;p70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40" name="Google Shape;440;p70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41" name="Google Shape;441;p70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42" name="Google Shape;442;p70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43" name="Google Shape;443;p70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44" name="Google Shape;444;p70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445" name="Google Shape;445;p7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purple">
  <p:cSld name="k. key facts purpl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4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Google Shape;447;p71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3C003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48" name="Google Shape;448;p71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3C003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49" name="Google Shape;449;p71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3C003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50" name="Google Shape;450;p71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51" name="Google Shape;451;p71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52" name="Google Shape;452;p71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53" name="Google Shape;453;p71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54" name="Google Shape;454;p71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55" name="Google Shape;455;p71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56" name="Google Shape;456;p71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57" name="Google Shape;457;p71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58" name="Google Shape;458;p71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59" name="Google Shape;459;p71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60" name="Google Shape;460;p71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61" name="Google Shape;461;p71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62" name="Google Shape;462;p71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463" name="Google Shape;463;p7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purple">
  <p:cSld name="a. title slide purple">
    <p:bg>
      <p:bgPr>
        <a:solidFill>
          <a:srgbClr val="3C0032"/>
        </a:solidFill>
        <a:effectLst/>
      </p:bgPr>
    </p:bg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9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900"/>
              <a:buNone/>
              <a:defRPr sz="7866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45" name="Google Shape;45;p9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46" name="Google Shape;46;p9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89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50"/>
              <a:buFont typeface="Inter"/>
              <a:buNone/>
              <a:defRPr sz="1667" b="0">
                <a:solidFill>
                  <a:schemeClr val="lt1"/>
                </a:solidFill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47" name="Google Shape;47;p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1" y="100801"/>
            <a:ext cx="2260801" cy="22608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dark green">
  <p:cSld name="k. key facts dark green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4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Google Shape;465;p72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144835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66" name="Google Shape;466;p72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144835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67" name="Google Shape;467;p72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144835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68" name="Google Shape;468;p72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69" name="Google Shape;469;p72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70" name="Google Shape;470;p72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71" name="Google Shape;471;p72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72" name="Google Shape;472;p72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73" name="Google Shape;473;p72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74" name="Google Shape;474;p72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75" name="Google Shape;475;p72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76" name="Google Shape;476;p72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77" name="Google Shape;477;p72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78" name="Google Shape;478;p72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79" name="Google Shape;479;p72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80" name="Google Shape;480;p72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481" name="Google Shape;481;p7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k. key facts light green">
  <p:cSld name="k. key facts light green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4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" name="Google Shape;483;p73"/>
          <p:cNvSpPr/>
          <p:nvPr/>
        </p:nvSpPr>
        <p:spPr>
          <a:xfrm>
            <a:off x="1645933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78BF2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4" name="Google Shape;484;p73"/>
          <p:cNvSpPr/>
          <p:nvPr/>
        </p:nvSpPr>
        <p:spPr>
          <a:xfrm>
            <a:off x="5158800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78BF2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5" name="Google Shape;485;p73"/>
          <p:cNvSpPr/>
          <p:nvPr/>
        </p:nvSpPr>
        <p:spPr>
          <a:xfrm>
            <a:off x="8671667" y="2395733"/>
            <a:ext cx="1874400" cy="1819600"/>
          </a:xfrm>
          <a:prstGeom prst="roundRect">
            <a:avLst>
              <a:gd name="adj" fmla="val 16667"/>
            </a:avLst>
          </a:prstGeom>
          <a:solidFill>
            <a:srgbClr val="E6E4DB"/>
          </a:solidFill>
          <a:ln w="76200" cap="flat" cmpd="sng">
            <a:solidFill>
              <a:srgbClr val="78BF2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6" name="Google Shape;486;p73"/>
          <p:cNvSpPr txBox="1">
            <a:spLocks noGrp="1"/>
          </p:cNvSpPr>
          <p:nvPr>
            <p:ph type="subTitle" idx="1"/>
          </p:nvPr>
        </p:nvSpPr>
        <p:spPr>
          <a:xfrm>
            <a:off x="1792233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87" name="Google Shape;487;p73"/>
          <p:cNvCxnSpPr/>
          <p:nvPr/>
        </p:nvCxnSpPr>
        <p:spPr>
          <a:xfrm rot="10800000">
            <a:off x="2036733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88" name="Google Shape;488;p73"/>
          <p:cNvSpPr txBox="1">
            <a:spLocks noGrp="1"/>
          </p:cNvSpPr>
          <p:nvPr>
            <p:ph type="subTitle" idx="2"/>
          </p:nvPr>
        </p:nvSpPr>
        <p:spPr>
          <a:xfrm>
            <a:off x="53050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89" name="Google Shape;489;p73"/>
          <p:cNvCxnSpPr/>
          <p:nvPr/>
        </p:nvCxnSpPr>
        <p:spPr>
          <a:xfrm rot="10800000">
            <a:off x="55495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90" name="Google Shape;490;p73"/>
          <p:cNvSpPr txBox="1">
            <a:spLocks noGrp="1"/>
          </p:cNvSpPr>
          <p:nvPr>
            <p:ph type="subTitle" idx="3"/>
          </p:nvPr>
        </p:nvSpPr>
        <p:spPr>
          <a:xfrm>
            <a:off x="8817851" y="33375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333" b="1">
                <a:solidFill>
                  <a:schemeClr val="dk1"/>
                </a:solidFill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"/>
              <a:buNone/>
              <a:defRPr sz="800" b="1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cxnSp>
        <p:nvCxnSpPr>
          <p:cNvPr id="491" name="Google Shape;491;p73"/>
          <p:cNvCxnSpPr/>
          <p:nvPr/>
        </p:nvCxnSpPr>
        <p:spPr>
          <a:xfrm rot="10800000">
            <a:off x="9062351" y="3337567"/>
            <a:ext cx="1092800" cy="0"/>
          </a:xfrm>
          <a:prstGeom prst="straightConnector1">
            <a:avLst/>
          </a:prstGeom>
          <a:noFill/>
          <a:ln w="9525" cap="flat" cmpd="sng">
            <a:solidFill>
              <a:srgbClr val="434343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492" name="Google Shape;492;p73"/>
          <p:cNvSpPr txBox="1">
            <a:spLocks noGrp="1"/>
          </p:cNvSpPr>
          <p:nvPr>
            <p:ph type="subTitle" idx="4"/>
          </p:nvPr>
        </p:nvSpPr>
        <p:spPr>
          <a:xfrm>
            <a:off x="982933" y="4484533"/>
            <a:ext cx="3200400" cy="7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93" name="Google Shape;493;p73"/>
          <p:cNvSpPr txBox="1">
            <a:spLocks noGrp="1"/>
          </p:cNvSpPr>
          <p:nvPr>
            <p:ph type="subTitle" idx="5"/>
          </p:nvPr>
        </p:nvSpPr>
        <p:spPr>
          <a:xfrm>
            <a:off x="4495800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94" name="Google Shape;494;p73"/>
          <p:cNvSpPr txBox="1">
            <a:spLocks noGrp="1"/>
          </p:cNvSpPr>
          <p:nvPr>
            <p:ph type="subTitle" idx="6"/>
          </p:nvPr>
        </p:nvSpPr>
        <p:spPr>
          <a:xfrm>
            <a:off x="8008667" y="4484533"/>
            <a:ext cx="3200400" cy="85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500"/>
              <a:buFont typeface="Inter SemiBold"/>
              <a:buNone/>
              <a:defRPr sz="2000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Hind"/>
              <a:buNone/>
              <a:defRPr sz="1467" b="1">
                <a:solidFill>
                  <a:schemeClr val="dk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495" name="Google Shape;495;p73"/>
          <p:cNvSpPr txBox="1">
            <a:spLocks noGrp="1"/>
          </p:cNvSpPr>
          <p:nvPr>
            <p:ph type="subTitle" idx="7"/>
          </p:nvPr>
        </p:nvSpPr>
        <p:spPr>
          <a:xfrm>
            <a:off x="1792133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96" name="Google Shape;496;p73"/>
          <p:cNvSpPr txBox="1">
            <a:spLocks noGrp="1"/>
          </p:cNvSpPr>
          <p:nvPr>
            <p:ph type="subTitle" idx="8"/>
          </p:nvPr>
        </p:nvSpPr>
        <p:spPr>
          <a:xfrm>
            <a:off x="53049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97" name="Google Shape;497;p73"/>
          <p:cNvSpPr txBox="1">
            <a:spLocks noGrp="1"/>
          </p:cNvSpPr>
          <p:nvPr>
            <p:ph type="subTitle" idx="9"/>
          </p:nvPr>
        </p:nvSpPr>
        <p:spPr>
          <a:xfrm>
            <a:off x="8817751" y="2596767"/>
            <a:ext cx="1582000" cy="74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00"/>
              <a:buFont typeface="Roboto Condensed"/>
              <a:buNone/>
              <a:defRPr sz="48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2pPr>
            <a:lvl3pPr lvl="2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3pPr>
            <a:lvl4pPr lvl="3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4pPr>
            <a:lvl5pPr lvl="4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5pPr>
            <a:lvl6pPr lvl="5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6pPr>
            <a:lvl7pPr lvl="6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7pPr>
            <a:lvl8pPr lvl="7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0"/>
              <a:buFont typeface="Roboto Condensed"/>
              <a:buNone/>
              <a:defRPr sz="667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8pPr>
            <a:lvl9pPr lvl="8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Roboto Condensed"/>
              <a:buNone/>
              <a:defRPr sz="5200" b="1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9pPr>
          </a:lstStyle>
          <a:p>
            <a:endParaRPr/>
          </a:p>
        </p:txBody>
      </p:sp>
      <p:sp>
        <p:nvSpPr>
          <p:cNvPr id="498" name="Google Shape;498;p73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499" name="Google Shape;499;p7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dark green">
  <p:cSld name="l. text columns dark green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Google Shape;501;p74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02" name="Google Shape;502;p74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03" name="Google Shape;503;p74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04" name="Google Shape;504;p74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05" name="Google Shape;505;p74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06" name="Google Shape;506;p7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light green">
  <p:cSld name="l. text columns light green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8" name="Google Shape;508;p75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09" name="Google Shape;509;p75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10" name="Google Shape;510;p75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11" name="Google Shape;511;p75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12" name="Google Shape;512;p75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13" name="Google Shape;513;p7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warm grey">
  <p:cSld name="l. text columns warm grey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Google Shape;515;p76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16" name="Google Shape;516;p76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17" name="Google Shape;517;p76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8" name="Google Shape;518;p76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9" name="Google Shape;519;p76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20" name="Google Shape;520;p7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orange">
  <p:cSld name="l. text columns orang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" name="Google Shape;522;p77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23" name="Google Shape;523;p77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24" name="Google Shape;524;p77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5" name="Google Shape;525;p77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6" name="Google Shape;526;p77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None/>
              <a:defRPr sz="453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27" name="Google Shape;527;p7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yellow">
  <p:cSld name="l. text columns yellow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Google Shape;529;p78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Inter"/>
              <a:buChar char="●"/>
              <a:defRPr sz="2667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9pPr>
          </a:lstStyle>
          <a:p>
            <a:endParaRPr/>
          </a:p>
        </p:txBody>
      </p:sp>
      <p:sp>
        <p:nvSpPr>
          <p:cNvPr id="530" name="Google Shape;530;p78"/>
          <p:cNvSpPr txBox="1">
            <a:spLocks noGrp="1"/>
          </p:cNvSpPr>
          <p:nvPr>
            <p:ph type="subTitle" idx="2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1" name="Google Shape;531;p78"/>
          <p:cNvSpPr txBox="1">
            <a:spLocks noGrp="1"/>
          </p:cNvSpPr>
          <p:nvPr>
            <p:ph type="subTitle" idx="3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2" name="Google Shape;532;p78"/>
          <p:cNvSpPr txBox="1">
            <a:spLocks noGrp="1"/>
          </p:cNvSpPr>
          <p:nvPr>
            <p:ph type="body" idx="4"/>
          </p:nvPr>
        </p:nvSpPr>
        <p:spPr>
          <a:xfrm>
            <a:off x="66312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Inter"/>
              <a:buChar char="●"/>
              <a:defRPr sz="2667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9pPr>
          </a:lstStyle>
          <a:p>
            <a:endParaRPr/>
          </a:p>
        </p:txBody>
      </p:sp>
      <p:sp>
        <p:nvSpPr>
          <p:cNvPr id="533" name="Google Shape;533;p78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400"/>
              <a:buFont typeface="Roboto Condensed"/>
              <a:buNone/>
              <a:defRPr sz="4533" b="1"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Font typeface="Bebas Neue"/>
              <a:buNone/>
              <a:defRPr b="1"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34" name="Google Shape;534;p7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300" y="99933"/>
            <a:ext cx="1982232" cy="19822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purple">
  <p:cSld name="l. text columns purpl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Google Shape;536;p79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37" name="Google Shape;537;p79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38" name="Google Shape;538;p79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39" name="Google Shape;539;p79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40" name="Google Shape;540;p79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41" name="Google Shape;541;p7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. text columns dark blue">
  <p:cSld name="l. text columns dark blue">
    <p:bg>
      <p:bgPr>
        <a:blipFill>
          <a:blip r:embed="rId2">
            <a:alphaModFix/>
          </a:blip>
          <a:stretch>
            <a:fillRect/>
          </a:stretch>
        </a:blipFill>
        <a:effectLst/>
      </p:bgPr>
    </p:bg>
    <p:spTree>
      <p:nvGrpSpPr>
        <p:cNvPr id="1" name="Shape 5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3" name="Google Shape;543;p80"/>
          <p:cNvSpPr txBox="1">
            <a:spLocks noGrp="1"/>
          </p:cNvSpPr>
          <p:nvPr>
            <p:ph type="body" idx="1"/>
          </p:nvPr>
        </p:nvSpPr>
        <p:spPr>
          <a:xfrm>
            <a:off x="4190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44" name="Google Shape;544;p80"/>
          <p:cNvSpPr txBox="1">
            <a:spLocks noGrp="1"/>
          </p:cNvSpPr>
          <p:nvPr>
            <p:ph type="body" idx="2"/>
          </p:nvPr>
        </p:nvSpPr>
        <p:spPr>
          <a:xfrm>
            <a:off x="6628833" y="2725900"/>
            <a:ext cx="5113200" cy="405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55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Char char="●"/>
              <a:defRPr sz="2667">
                <a:solidFill>
                  <a:schemeClr val="dk1"/>
                </a:solidFill>
              </a:defRPr>
            </a:lvl1pPr>
            <a:lvl2pPr marL="914400" lvl="1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2pPr>
            <a:lvl3pPr marL="1371600" lvl="2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3pPr>
            <a:lvl4pPr marL="1828800" lvl="3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4pPr>
            <a:lvl5pPr marL="2286000" lvl="4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5pPr>
            <a:lvl6pPr marL="2743200" lvl="5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6pPr>
            <a:lvl7pPr marL="3200400" lvl="6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>
                <a:solidFill>
                  <a:schemeClr val="dk1"/>
                </a:solidFill>
              </a:defRPr>
            </a:lvl7pPr>
            <a:lvl8pPr marL="3657600" lvl="7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>
                <a:solidFill>
                  <a:schemeClr val="dk1"/>
                </a:solidFill>
              </a:defRPr>
            </a:lvl8pPr>
            <a:lvl9pPr marL="4114800" lvl="8" indent="-3175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545" name="Google Shape;545;p80"/>
          <p:cNvSpPr txBox="1">
            <a:spLocks noGrp="1"/>
          </p:cNvSpPr>
          <p:nvPr>
            <p:ph type="subTitle" idx="3"/>
          </p:nvPr>
        </p:nvSpPr>
        <p:spPr>
          <a:xfrm>
            <a:off x="4336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46" name="Google Shape;546;p80"/>
          <p:cNvSpPr txBox="1">
            <a:spLocks noGrp="1"/>
          </p:cNvSpPr>
          <p:nvPr>
            <p:ph type="subTitle" idx="4"/>
          </p:nvPr>
        </p:nvSpPr>
        <p:spPr>
          <a:xfrm>
            <a:off x="6631233" y="1983133"/>
            <a:ext cx="5468000" cy="63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Inter SemiBold"/>
              <a:buNone/>
              <a:defRPr sz="2933">
                <a:solidFill>
                  <a:schemeClr val="dk1"/>
                </a:solidFill>
                <a:latin typeface="Inter SemiBold"/>
                <a:ea typeface="Inter SemiBold"/>
                <a:cs typeface="Inter SemiBold"/>
                <a:sym typeface="Inter SemiBold"/>
              </a:defRPr>
            </a:lvl1pPr>
            <a:lvl2pPr lvl="1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2pPr>
            <a:lvl3pPr lvl="2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3pPr>
            <a:lvl4pPr lvl="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4pPr>
            <a:lvl5pPr lvl="4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5pPr>
            <a:lvl6pPr lvl="5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6pPr>
            <a:lvl7pPr lvl="6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7pPr>
            <a:lvl8pPr lvl="7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8pPr>
            <a:lvl9pPr lvl="8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Font typeface="Inter SemiBold"/>
              <a:buNone/>
              <a:defRPr>
                <a:latin typeface="Inter SemiBold"/>
                <a:ea typeface="Inter SemiBold"/>
                <a:cs typeface="Inter SemiBold"/>
                <a:sym typeface="Inter SemiBold"/>
              </a:defRPr>
            </a:lvl9pPr>
          </a:lstStyle>
          <a:p>
            <a:endParaRPr/>
          </a:p>
        </p:txBody>
      </p:sp>
      <p:sp>
        <p:nvSpPr>
          <p:cNvPr id="547" name="Google Shape;547;p80"/>
          <p:cNvSpPr txBox="1">
            <a:spLocks noGrp="1"/>
          </p:cNvSpPr>
          <p:nvPr>
            <p:ph type="title"/>
          </p:nvPr>
        </p:nvSpPr>
        <p:spPr>
          <a:xfrm>
            <a:off x="419033" y="348067"/>
            <a:ext cx="9175200" cy="104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400"/>
              <a:buNone/>
              <a:defRPr sz="4533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Bebas Neue"/>
              <a:buNone/>
              <a:defRPr b="1">
                <a:solidFill>
                  <a:schemeClr val="lt1"/>
                </a:solidFill>
                <a:latin typeface="Bebas Neue"/>
                <a:ea typeface="Bebas Neue"/>
                <a:cs typeface="Bebas Neue"/>
                <a:sym typeface="Bebas Neue"/>
              </a:defRPr>
            </a:lvl9pPr>
          </a:lstStyle>
          <a:p>
            <a:endParaRPr/>
          </a:p>
        </p:txBody>
      </p:sp>
      <p:pic>
        <p:nvPicPr>
          <p:cNvPr id="548" name="Google Shape;548;p8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915216" y="100800"/>
            <a:ext cx="1982403" cy="19824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light grey">
  <p:cSld name="i. statement and image light grey">
    <p:bg>
      <p:bgPr>
        <a:solidFill>
          <a:srgbClr val="E6E4DB"/>
        </a:solidFill>
        <a:effectLst/>
      </p:bgPr>
    </p:bg>
    <p:spTree>
      <p:nvGrpSpPr>
        <p:cNvPr id="1" name="Shape 5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0" name="Google Shape;550;p81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51" name="Google Shape;551;p81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52" name="Google Shape;552;p81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warm grey">
  <p:cSld name="a. title slide warm grey">
    <p:bg>
      <p:bgPr>
        <a:solidFill>
          <a:srgbClr val="A6A091"/>
        </a:solidFill>
        <a:effectLst/>
      </p:bgPr>
    </p:bg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0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840000" cy="409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5900"/>
              <a:buNone/>
              <a:defRPr sz="7866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title" idx="2"/>
          </p:nvPr>
        </p:nvSpPr>
        <p:spPr>
          <a:xfrm>
            <a:off x="493633" y="585500"/>
            <a:ext cx="3754000" cy="94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50"/>
              <a:buFont typeface="Inter"/>
              <a:buNone/>
              <a:defRPr sz="1667" b="0"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52" name="Google Shape;52;p1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0" y="100800"/>
            <a:ext cx="2258835" cy="225883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yellow">
  <p:cSld name="i. statement and image yellow">
    <p:bg>
      <p:bgPr>
        <a:solidFill>
          <a:srgbClr val="FFD200"/>
        </a:solidFill>
        <a:effectLst/>
      </p:bgPr>
    </p:bg>
    <p:spTree>
      <p:nvGrpSpPr>
        <p:cNvPr id="1" name="Shape 5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4" name="Google Shape;554;p82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55" name="Google Shape;555;p82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56" name="Google Shape;556;p82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orange">
  <p:cSld name="i. statement and image orange">
    <p:bg>
      <p:bgPr>
        <a:solidFill>
          <a:srgbClr val="FD5000"/>
        </a:solidFill>
        <a:effectLst/>
      </p:bgPr>
    </p:bg>
    <p:spTree>
      <p:nvGrpSpPr>
        <p:cNvPr id="1" name="Shape 5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8" name="Google Shape;558;p83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59" name="Google Shape;559;p83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60" name="Google Shape;560;p83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light green">
  <p:cSld name="i. statement and image light green">
    <p:bg>
      <p:bgPr>
        <a:solidFill>
          <a:srgbClr val="78BF26"/>
        </a:solidFill>
        <a:effectLst/>
      </p:bgPr>
    </p:bg>
    <p:spTree>
      <p:nvGrpSpPr>
        <p:cNvPr id="1" name="Shape 5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Google Shape;562;p84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63" name="Google Shape;563;p84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64" name="Google Shape;564;p84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warm grey">
  <p:cSld name="i. statement and image warm grey">
    <p:bg>
      <p:bgPr>
        <a:solidFill>
          <a:srgbClr val="A6A091"/>
        </a:solidFill>
        <a:effectLst/>
      </p:bgPr>
    </p:bg>
    <p:spTree>
      <p:nvGrpSpPr>
        <p:cNvPr id="1" name="Shape 5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6" name="Google Shape;566;p85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67" name="Google Shape;567;p85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68" name="Google Shape;568;p85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000"/>
              <a:buNone/>
              <a:defRPr sz="66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dark blue">
  <p:cSld name="i. statement and image dark blue">
    <p:bg>
      <p:bgPr>
        <a:solidFill>
          <a:srgbClr val="001E82"/>
        </a:solidFill>
        <a:effectLst/>
      </p:bgPr>
    </p:bg>
    <p:spTree>
      <p:nvGrpSpPr>
        <p:cNvPr id="1" name="Shape 5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0" name="Google Shape;570;p86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71" name="Google Shape;571;p86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72" name="Google Shape;572;p86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purple">
  <p:cSld name="i. statement and image purple">
    <p:bg>
      <p:bgPr>
        <a:solidFill>
          <a:srgbClr val="3C0032"/>
        </a:solidFill>
        <a:effectLst/>
      </p:bgPr>
    </p:bg>
    <p:spTree>
      <p:nvGrpSpPr>
        <p:cNvPr id="1" name="Shape 5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4" name="Google Shape;574;p87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75" name="Google Shape;575;p87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76" name="Google Shape;576;p87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. statement and image dark green">
  <p:cSld name="i. statement and image dark green">
    <p:bg>
      <p:bgPr>
        <a:solidFill>
          <a:srgbClr val="144835"/>
        </a:solidFill>
        <a:effectLst/>
      </p:bgPr>
    </p:bg>
    <p:spTree>
      <p:nvGrpSpPr>
        <p:cNvPr id="1" name="Shape 5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Google Shape;578;p88"/>
          <p:cNvSpPr>
            <a:spLocks noGrp="1"/>
          </p:cNvSpPr>
          <p:nvPr>
            <p:ph type="pic" idx="2"/>
          </p:nvPr>
        </p:nvSpPr>
        <p:spPr>
          <a:xfrm>
            <a:off x="2860800" y="1440000"/>
            <a:ext cx="6499200" cy="3974400"/>
          </a:xfrm>
          <a:prstGeom prst="roundRect">
            <a:avLst>
              <a:gd name="adj" fmla="val 8896"/>
            </a:avLst>
          </a:prstGeom>
          <a:noFill/>
          <a:ln>
            <a:noFill/>
          </a:ln>
        </p:spPr>
      </p:sp>
      <p:sp>
        <p:nvSpPr>
          <p:cNvPr id="579" name="Google Shape;579;p88"/>
          <p:cNvSpPr txBox="1">
            <a:spLocks noGrp="1"/>
          </p:cNvSpPr>
          <p:nvPr>
            <p:ph type="title"/>
          </p:nvPr>
        </p:nvSpPr>
        <p:spPr>
          <a:xfrm>
            <a:off x="1531200" y="144000"/>
            <a:ext cx="55152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sp>
        <p:nvSpPr>
          <p:cNvPr id="580" name="Google Shape;580;p88"/>
          <p:cNvSpPr txBox="1">
            <a:spLocks noGrp="1"/>
          </p:cNvSpPr>
          <p:nvPr>
            <p:ph type="title" idx="3"/>
          </p:nvPr>
        </p:nvSpPr>
        <p:spPr>
          <a:xfrm>
            <a:off x="5851200" y="5188800"/>
            <a:ext cx="6096000" cy="156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000"/>
              <a:buNone/>
              <a:defRPr sz="6667">
                <a:solidFill>
                  <a:schemeClr val="lt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8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dark blue">
  <p:cSld name="h. end slide dark blue">
    <p:bg>
      <p:bgPr>
        <a:solidFill>
          <a:srgbClr val="001E82"/>
        </a:solidFill>
        <a:effectLst/>
      </p:bgPr>
    </p:bg>
    <p:spTree>
      <p:nvGrpSpPr>
        <p:cNvPr id="1" name="Shape 5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Google Shape;582;p89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83" name="Google Shape;583;p89"/>
          <p:cNvSpPr txBox="1">
            <a:spLocks noGrp="1"/>
          </p:cNvSpPr>
          <p:nvPr>
            <p:ph type="title"/>
          </p:nvPr>
        </p:nvSpPr>
        <p:spPr>
          <a:xfrm>
            <a:off x="747300" y="5273233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584" name="Google Shape;584;p89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5034" y="379401"/>
            <a:ext cx="4485201" cy="4485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8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orange">
  <p:cSld name="h. end slide orange">
    <p:bg>
      <p:bgPr>
        <a:solidFill>
          <a:srgbClr val="FD5000"/>
        </a:solidFill>
        <a:effectLst/>
      </p:bgPr>
    </p:bg>
    <p:spTree>
      <p:nvGrpSpPr>
        <p:cNvPr id="1" name="Shape 5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Google Shape;586;p90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87" name="Google Shape;587;p90"/>
          <p:cNvSpPr txBox="1">
            <a:spLocks noGrp="1"/>
          </p:cNvSpPr>
          <p:nvPr>
            <p:ph type="title"/>
          </p:nvPr>
        </p:nvSpPr>
        <p:spPr>
          <a:xfrm>
            <a:off x="748800" y="5275200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588" name="Google Shape;588;p90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3601" y="379201"/>
            <a:ext cx="4483201" cy="4483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8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yellow">
  <p:cSld name="h. end slide yellow">
    <p:bg>
      <p:bgPr>
        <a:solidFill>
          <a:srgbClr val="FFD200"/>
        </a:solidFill>
        <a:effectLst/>
      </p:bgPr>
    </p:bg>
    <p:spTree>
      <p:nvGrpSpPr>
        <p:cNvPr id="1" name="Shape 5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Google Shape;590;p91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91" name="Google Shape;591;p91"/>
          <p:cNvSpPr txBox="1">
            <a:spLocks noGrp="1"/>
          </p:cNvSpPr>
          <p:nvPr>
            <p:ph type="title"/>
          </p:nvPr>
        </p:nvSpPr>
        <p:spPr>
          <a:xfrm>
            <a:off x="748800" y="5275200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592" name="Google Shape;592;p9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3601" y="379201"/>
            <a:ext cx="4483201" cy="4483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. title slide full page background image">
  <p:cSld name="a. title slide full page background image">
    <p:bg>
      <p:bgPr>
        <a:solidFill>
          <a:schemeClr val="lt1"/>
        </a:solidFill>
        <a:effectLst/>
      </p:bgPr>
    </p:bg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1"/>
          <p:cNvSpPr>
            <a:spLocks noGrp="1"/>
          </p:cNvSpPr>
          <p:nvPr>
            <p:ph type="pic" idx="2"/>
          </p:nvPr>
        </p:nvSpPr>
        <p:spPr>
          <a:xfrm>
            <a:off x="0" y="0"/>
            <a:ext cx="12192000" cy="6858000"/>
          </a:xfrm>
          <a:prstGeom prst="rect">
            <a:avLst/>
          </a:prstGeom>
          <a:noFill/>
          <a:ln>
            <a:noFill/>
          </a:ln>
        </p:spPr>
      </p:sp>
      <p:sp>
        <p:nvSpPr>
          <p:cNvPr id="55" name="Google Shape;55;p11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ctrTitle"/>
          </p:nvPr>
        </p:nvSpPr>
        <p:spPr>
          <a:xfrm>
            <a:off x="415600" y="1989967"/>
            <a:ext cx="6074000" cy="50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5900"/>
              <a:buNone/>
              <a:defRPr sz="7866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6933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title" idx="3"/>
          </p:nvPr>
        </p:nvSpPr>
        <p:spPr>
          <a:xfrm>
            <a:off x="493633" y="585500"/>
            <a:ext cx="3754000" cy="88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50"/>
              <a:buFont typeface="Inter"/>
              <a:buNone/>
              <a:defRPr sz="1667" b="0">
                <a:latin typeface="Inter"/>
                <a:ea typeface="Inter"/>
                <a:cs typeface="Inter"/>
                <a:sym typeface="Inter"/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pic>
        <p:nvPicPr>
          <p:cNvPr id="58" name="Google Shape;58;p11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792000" y="100800"/>
            <a:ext cx="2258835" cy="225883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light green">
  <p:cSld name="h. end slide light green">
    <p:bg>
      <p:bgPr>
        <a:solidFill>
          <a:srgbClr val="78BF26"/>
        </a:solidFill>
        <a:effectLst/>
      </p:bgPr>
    </p:bg>
    <p:spTree>
      <p:nvGrpSpPr>
        <p:cNvPr id="1" name="Shape 5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4" name="Google Shape;594;p92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95" name="Google Shape;595;p92"/>
          <p:cNvSpPr txBox="1">
            <a:spLocks noGrp="1"/>
          </p:cNvSpPr>
          <p:nvPr>
            <p:ph type="title"/>
          </p:nvPr>
        </p:nvSpPr>
        <p:spPr>
          <a:xfrm>
            <a:off x="748800" y="5275200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596" name="Google Shape;596;p92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3601" y="379201"/>
            <a:ext cx="4483201" cy="4483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dark green">
  <p:cSld name="h. end slide dark green">
    <p:bg>
      <p:bgPr>
        <a:solidFill>
          <a:srgbClr val="144835"/>
        </a:solidFill>
        <a:effectLst/>
      </p:bgPr>
    </p:bg>
    <p:spTree>
      <p:nvGrpSpPr>
        <p:cNvPr id="1" name="Shape 5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Google Shape;598;p93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99" name="Google Shape;599;p93"/>
          <p:cNvSpPr txBox="1">
            <a:spLocks noGrp="1"/>
          </p:cNvSpPr>
          <p:nvPr>
            <p:ph type="title"/>
          </p:nvPr>
        </p:nvSpPr>
        <p:spPr>
          <a:xfrm>
            <a:off x="747300" y="5273233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600" name="Google Shape;600;p93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5034" y="379401"/>
            <a:ext cx="4485201" cy="4485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purple">
  <p:cSld name="h. end slide purple">
    <p:bg>
      <p:bgPr>
        <a:solidFill>
          <a:srgbClr val="3C0032"/>
        </a:solidFill>
        <a:effectLst/>
      </p:bgPr>
    </p:bg>
    <p:spTree>
      <p:nvGrpSpPr>
        <p:cNvPr id="1" name="Shape 6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2" name="Google Shape;602;p9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603" name="Google Shape;603;p94"/>
          <p:cNvSpPr txBox="1">
            <a:spLocks noGrp="1"/>
          </p:cNvSpPr>
          <p:nvPr>
            <p:ph type="title"/>
          </p:nvPr>
        </p:nvSpPr>
        <p:spPr>
          <a:xfrm>
            <a:off x="747300" y="5273233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None/>
              <a:defRPr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604" name="Google Shape;604;p94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5034" y="379401"/>
            <a:ext cx="4485201" cy="4485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light grey">
  <p:cSld name="h. end slide light grey">
    <p:bg>
      <p:bgPr>
        <a:solidFill>
          <a:srgbClr val="A6A091"/>
        </a:solidFill>
        <a:effectLst/>
      </p:bgPr>
    </p:bg>
    <p:spTree>
      <p:nvGrpSpPr>
        <p:cNvPr id="1" name="Shape 6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6" name="Google Shape;606;p95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607" name="Google Shape;607;p95"/>
          <p:cNvSpPr txBox="1">
            <a:spLocks noGrp="1"/>
          </p:cNvSpPr>
          <p:nvPr>
            <p:ph type="title"/>
          </p:nvPr>
        </p:nvSpPr>
        <p:spPr>
          <a:xfrm>
            <a:off x="748800" y="5275200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608" name="Google Shape;608;p95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3601" y="379201"/>
            <a:ext cx="4483201" cy="4483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Layouts/slideLayout9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h. end slide light grey">
  <p:cSld name="1_h. end slide light grey">
    <p:bg>
      <p:bgPr>
        <a:solidFill>
          <a:srgbClr val="E6E4DB"/>
        </a:solidFill>
        <a:effectLst/>
      </p:bgPr>
    </p:bg>
    <p:spTree>
      <p:nvGrpSpPr>
        <p:cNvPr id="1" name="Shape 6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0" name="Google Shape;610;p96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lvl="0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buClr>
                <a:schemeClr val="dk2"/>
              </a:buClr>
              <a:buSzPts val="1333"/>
              <a:buFont typeface="Arial"/>
              <a:buNone/>
              <a:defRPr sz="1333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611" name="Google Shape;611;p96"/>
          <p:cNvSpPr txBox="1">
            <a:spLocks noGrp="1"/>
          </p:cNvSpPr>
          <p:nvPr>
            <p:ph type="title"/>
          </p:nvPr>
        </p:nvSpPr>
        <p:spPr>
          <a:xfrm>
            <a:off x="748800" y="5275200"/>
            <a:ext cx="7004800" cy="63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>
                <a:latin typeface="Hind"/>
                <a:ea typeface="Hind"/>
                <a:cs typeface="Hind"/>
                <a:sym typeface="Hind"/>
              </a:defRPr>
            </a:lvl9pPr>
          </a:lstStyle>
          <a:p>
            <a:endParaRPr/>
          </a:p>
        </p:txBody>
      </p:sp>
      <p:pic>
        <p:nvPicPr>
          <p:cNvPr id="612" name="Google Shape;612;p96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513601" y="379201"/>
            <a:ext cx="4483201" cy="4483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6" Type="http://schemas.openxmlformats.org/officeDocument/2006/relationships/slideLayout" Target="../slideLayouts/slideLayout26.xml"/><Relationship Id="rId21" Type="http://schemas.openxmlformats.org/officeDocument/2006/relationships/slideLayout" Target="../slideLayouts/slideLayout21.xml"/><Relationship Id="rId42" Type="http://schemas.openxmlformats.org/officeDocument/2006/relationships/slideLayout" Target="../slideLayouts/slideLayout42.xml"/><Relationship Id="rId47" Type="http://schemas.openxmlformats.org/officeDocument/2006/relationships/slideLayout" Target="../slideLayouts/slideLayout47.xml"/><Relationship Id="rId63" Type="http://schemas.openxmlformats.org/officeDocument/2006/relationships/slideLayout" Target="../slideLayouts/slideLayout63.xml"/><Relationship Id="rId68" Type="http://schemas.openxmlformats.org/officeDocument/2006/relationships/slideLayout" Target="../slideLayouts/slideLayout68.xml"/><Relationship Id="rId84" Type="http://schemas.openxmlformats.org/officeDocument/2006/relationships/slideLayout" Target="../slideLayouts/slideLayout84.xml"/><Relationship Id="rId89" Type="http://schemas.openxmlformats.org/officeDocument/2006/relationships/slideLayout" Target="../slideLayouts/slideLayout89.xml"/><Relationship Id="rId16" Type="http://schemas.openxmlformats.org/officeDocument/2006/relationships/slideLayout" Target="../slideLayouts/slideLayout16.xml"/><Relationship Id="rId11" Type="http://schemas.openxmlformats.org/officeDocument/2006/relationships/slideLayout" Target="../slideLayouts/slideLayout11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53" Type="http://schemas.openxmlformats.org/officeDocument/2006/relationships/slideLayout" Target="../slideLayouts/slideLayout53.xml"/><Relationship Id="rId58" Type="http://schemas.openxmlformats.org/officeDocument/2006/relationships/slideLayout" Target="../slideLayouts/slideLayout58.xml"/><Relationship Id="rId74" Type="http://schemas.openxmlformats.org/officeDocument/2006/relationships/slideLayout" Target="../slideLayouts/slideLayout74.xml"/><Relationship Id="rId79" Type="http://schemas.openxmlformats.org/officeDocument/2006/relationships/slideLayout" Target="../slideLayouts/slideLayout79.xml"/><Relationship Id="rId5" Type="http://schemas.openxmlformats.org/officeDocument/2006/relationships/slideLayout" Target="../slideLayouts/slideLayout5.xml"/><Relationship Id="rId90" Type="http://schemas.openxmlformats.org/officeDocument/2006/relationships/slideLayout" Target="../slideLayouts/slideLayout90.xml"/><Relationship Id="rId95" Type="http://schemas.openxmlformats.org/officeDocument/2006/relationships/theme" Target="../theme/theme1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43" Type="http://schemas.openxmlformats.org/officeDocument/2006/relationships/slideLayout" Target="../slideLayouts/slideLayout43.xml"/><Relationship Id="rId48" Type="http://schemas.openxmlformats.org/officeDocument/2006/relationships/slideLayout" Target="../slideLayouts/slideLayout48.xml"/><Relationship Id="rId64" Type="http://schemas.openxmlformats.org/officeDocument/2006/relationships/slideLayout" Target="../slideLayouts/slideLayout64.xml"/><Relationship Id="rId69" Type="http://schemas.openxmlformats.org/officeDocument/2006/relationships/slideLayout" Target="../slideLayouts/slideLayout69.xml"/><Relationship Id="rId8" Type="http://schemas.openxmlformats.org/officeDocument/2006/relationships/slideLayout" Target="../slideLayouts/slideLayout8.xml"/><Relationship Id="rId51" Type="http://schemas.openxmlformats.org/officeDocument/2006/relationships/slideLayout" Target="../slideLayouts/slideLayout51.xml"/><Relationship Id="rId72" Type="http://schemas.openxmlformats.org/officeDocument/2006/relationships/slideLayout" Target="../slideLayouts/slideLayout72.xml"/><Relationship Id="rId80" Type="http://schemas.openxmlformats.org/officeDocument/2006/relationships/slideLayout" Target="../slideLayouts/slideLayout80.xml"/><Relationship Id="rId85" Type="http://schemas.openxmlformats.org/officeDocument/2006/relationships/slideLayout" Target="../slideLayouts/slideLayout85.xml"/><Relationship Id="rId93" Type="http://schemas.openxmlformats.org/officeDocument/2006/relationships/slideLayout" Target="../slideLayouts/slideLayout93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46" Type="http://schemas.openxmlformats.org/officeDocument/2006/relationships/slideLayout" Target="../slideLayouts/slideLayout46.xml"/><Relationship Id="rId59" Type="http://schemas.openxmlformats.org/officeDocument/2006/relationships/slideLayout" Target="../slideLayouts/slideLayout59.xml"/><Relationship Id="rId67" Type="http://schemas.openxmlformats.org/officeDocument/2006/relationships/slideLayout" Target="../slideLayouts/slideLayout67.xml"/><Relationship Id="rId20" Type="http://schemas.openxmlformats.org/officeDocument/2006/relationships/slideLayout" Target="../slideLayouts/slideLayout20.xml"/><Relationship Id="rId41" Type="http://schemas.openxmlformats.org/officeDocument/2006/relationships/slideLayout" Target="../slideLayouts/slideLayout41.xml"/><Relationship Id="rId54" Type="http://schemas.openxmlformats.org/officeDocument/2006/relationships/slideLayout" Target="../slideLayouts/slideLayout54.xml"/><Relationship Id="rId62" Type="http://schemas.openxmlformats.org/officeDocument/2006/relationships/slideLayout" Target="../slideLayouts/slideLayout62.xml"/><Relationship Id="rId70" Type="http://schemas.openxmlformats.org/officeDocument/2006/relationships/slideLayout" Target="../slideLayouts/slideLayout70.xml"/><Relationship Id="rId75" Type="http://schemas.openxmlformats.org/officeDocument/2006/relationships/slideLayout" Target="../slideLayouts/slideLayout75.xml"/><Relationship Id="rId83" Type="http://schemas.openxmlformats.org/officeDocument/2006/relationships/slideLayout" Target="../slideLayouts/slideLayout83.xml"/><Relationship Id="rId88" Type="http://schemas.openxmlformats.org/officeDocument/2006/relationships/slideLayout" Target="../slideLayouts/slideLayout88.xml"/><Relationship Id="rId91" Type="http://schemas.openxmlformats.org/officeDocument/2006/relationships/slideLayout" Target="../slideLayouts/slideLayout9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49" Type="http://schemas.openxmlformats.org/officeDocument/2006/relationships/slideLayout" Target="../slideLayouts/slideLayout49.xml"/><Relationship Id="rId57" Type="http://schemas.openxmlformats.org/officeDocument/2006/relationships/slideLayout" Target="../slideLayouts/slideLayout57.xml"/><Relationship Id="rId10" Type="http://schemas.openxmlformats.org/officeDocument/2006/relationships/slideLayout" Target="../slideLayouts/slideLayout10.xml"/><Relationship Id="rId31" Type="http://schemas.openxmlformats.org/officeDocument/2006/relationships/slideLayout" Target="../slideLayouts/slideLayout31.xml"/><Relationship Id="rId44" Type="http://schemas.openxmlformats.org/officeDocument/2006/relationships/slideLayout" Target="../slideLayouts/slideLayout44.xml"/><Relationship Id="rId52" Type="http://schemas.openxmlformats.org/officeDocument/2006/relationships/slideLayout" Target="../slideLayouts/slideLayout52.xml"/><Relationship Id="rId60" Type="http://schemas.openxmlformats.org/officeDocument/2006/relationships/slideLayout" Target="../slideLayouts/slideLayout60.xml"/><Relationship Id="rId65" Type="http://schemas.openxmlformats.org/officeDocument/2006/relationships/slideLayout" Target="../slideLayouts/slideLayout65.xml"/><Relationship Id="rId73" Type="http://schemas.openxmlformats.org/officeDocument/2006/relationships/slideLayout" Target="../slideLayouts/slideLayout73.xml"/><Relationship Id="rId78" Type="http://schemas.openxmlformats.org/officeDocument/2006/relationships/slideLayout" Target="../slideLayouts/slideLayout78.xml"/><Relationship Id="rId81" Type="http://schemas.openxmlformats.org/officeDocument/2006/relationships/slideLayout" Target="../slideLayouts/slideLayout81.xml"/><Relationship Id="rId86" Type="http://schemas.openxmlformats.org/officeDocument/2006/relationships/slideLayout" Target="../slideLayouts/slideLayout86.xml"/><Relationship Id="rId94" Type="http://schemas.openxmlformats.org/officeDocument/2006/relationships/slideLayout" Target="../slideLayouts/slideLayout94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9" Type="http://schemas.openxmlformats.org/officeDocument/2006/relationships/slideLayout" Target="../slideLayouts/slideLayout39.xml"/><Relationship Id="rId34" Type="http://schemas.openxmlformats.org/officeDocument/2006/relationships/slideLayout" Target="../slideLayouts/slideLayout34.xml"/><Relationship Id="rId50" Type="http://schemas.openxmlformats.org/officeDocument/2006/relationships/slideLayout" Target="../slideLayouts/slideLayout50.xml"/><Relationship Id="rId55" Type="http://schemas.openxmlformats.org/officeDocument/2006/relationships/slideLayout" Target="../slideLayouts/slideLayout55.xml"/><Relationship Id="rId76" Type="http://schemas.openxmlformats.org/officeDocument/2006/relationships/slideLayout" Target="../slideLayouts/slideLayout76.xml"/><Relationship Id="rId7" Type="http://schemas.openxmlformats.org/officeDocument/2006/relationships/slideLayout" Target="../slideLayouts/slideLayout7.xml"/><Relationship Id="rId71" Type="http://schemas.openxmlformats.org/officeDocument/2006/relationships/slideLayout" Target="../slideLayouts/slideLayout71.xml"/><Relationship Id="rId92" Type="http://schemas.openxmlformats.org/officeDocument/2006/relationships/slideLayout" Target="../slideLayouts/slideLayout92.xml"/><Relationship Id="rId2" Type="http://schemas.openxmlformats.org/officeDocument/2006/relationships/slideLayout" Target="../slideLayouts/slideLayout2.xml"/><Relationship Id="rId29" Type="http://schemas.openxmlformats.org/officeDocument/2006/relationships/slideLayout" Target="../slideLayouts/slideLayout29.xml"/><Relationship Id="rId24" Type="http://schemas.openxmlformats.org/officeDocument/2006/relationships/slideLayout" Target="../slideLayouts/slideLayout24.xml"/><Relationship Id="rId40" Type="http://schemas.openxmlformats.org/officeDocument/2006/relationships/slideLayout" Target="../slideLayouts/slideLayout40.xml"/><Relationship Id="rId45" Type="http://schemas.openxmlformats.org/officeDocument/2006/relationships/slideLayout" Target="../slideLayouts/slideLayout45.xml"/><Relationship Id="rId66" Type="http://schemas.openxmlformats.org/officeDocument/2006/relationships/slideLayout" Target="../slideLayouts/slideLayout66.xml"/><Relationship Id="rId87" Type="http://schemas.openxmlformats.org/officeDocument/2006/relationships/slideLayout" Target="../slideLayouts/slideLayout87.xml"/><Relationship Id="rId61" Type="http://schemas.openxmlformats.org/officeDocument/2006/relationships/slideLayout" Target="../slideLayouts/slideLayout61.xml"/><Relationship Id="rId82" Type="http://schemas.openxmlformats.org/officeDocument/2006/relationships/slideLayout" Target="../slideLayouts/slideLayout82.xml"/><Relationship Id="rId19" Type="http://schemas.openxmlformats.org/officeDocument/2006/relationships/slideLayout" Target="../slideLayouts/slideLayout19.xml"/><Relationship Id="rId14" Type="http://schemas.openxmlformats.org/officeDocument/2006/relationships/slideLayout" Target="../slideLayouts/slideLayout14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56" Type="http://schemas.openxmlformats.org/officeDocument/2006/relationships/slideLayout" Target="../slideLayouts/slideLayout56.xml"/><Relationship Id="rId77" Type="http://schemas.openxmlformats.org/officeDocument/2006/relationships/slideLayout" Target="../slideLayouts/slideLayout7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Roboto Condensed"/>
              <a:buNone/>
              <a:defRPr sz="2800" b="1" i="0" u="none" strike="noStrike" cap="none">
                <a:solidFill>
                  <a:schemeClr val="dk1"/>
                </a:solidFill>
                <a:latin typeface="Roboto Condensed"/>
                <a:ea typeface="Roboto Condensed"/>
                <a:cs typeface="Roboto Condensed"/>
                <a:sym typeface="Roboto Condensed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marR="0" lvl="0" indent="-342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Inter"/>
              <a:buChar char="●"/>
              <a:defRPr sz="1800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1pPr>
            <a:lvl2pPr marL="914400" marR="0" lvl="1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2pPr>
            <a:lvl3pPr marL="1371600" marR="0" lvl="2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3pPr>
            <a:lvl4pPr marL="1828800" marR="0" lvl="3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4pPr>
            <a:lvl5pPr marL="2286000" marR="0" lvl="4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5pPr>
            <a:lvl6pPr marL="2743200" marR="0" lvl="5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6pPr>
            <a:lvl7pPr marL="3200400" marR="0" lvl="6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●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7pPr>
            <a:lvl8pPr marL="3657600" marR="0" lvl="7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○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8pPr>
            <a:lvl9pPr marL="4114800" marR="0" lvl="8" indent="-3175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Inter"/>
              <a:buChar char="■"/>
              <a:defRPr sz="1867" b="0" i="0" u="none" strike="noStrike" cap="none">
                <a:solidFill>
                  <a:schemeClr val="dk1"/>
                </a:solidFill>
                <a:latin typeface="Inter"/>
                <a:ea typeface="Inter"/>
                <a:cs typeface="Inter"/>
                <a:sym typeface="Inter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buClr>
                <a:schemeClr val="dk2"/>
              </a:buClr>
              <a:buSzPts val="1333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  <p:sldLayoutId id="2147483665" r:id="rId17"/>
    <p:sldLayoutId id="2147483666" r:id="rId18"/>
    <p:sldLayoutId id="2147483667" r:id="rId19"/>
    <p:sldLayoutId id="2147483668" r:id="rId20"/>
    <p:sldLayoutId id="2147483669" r:id="rId21"/>
    <p:sldLayoutId id="2147483670" r:id="rId22"/>
    <p:sldLayoutId id="2147483671" r:id="rId23"/>
    <p:sldLayoutId id="2147483672" r:id="rId24"/>
    <p:sldLayoutId id="2147483673" r:id="rId25"/>
    <p:sldLayoutId id="2147483674" r:id="rId26"/>
    <p:sldLayoutId id="2147483675" r:id="rId27"/>
    <p:sldLayoutId id="2147483676" r:id="rId28"/>
    <p:sldLayoutId id="2147483677" r:id="rId29"/>
    <p:sldLayoutId id="2147483678" r:id="rId30"/>
    <p:sldLayoutId id="2147483679" r:id="rId31"/>
    <p:sldLayoutId id="2147483680" r:id="rId32"/>
    <p:sldLayoutId id="2147483681" r:id="rId33"/>
    <p:sldLayoutId id="2147483682" r:id="rId34"/>
    <p:sldLayoutId id="2147483683" r:id="rId35"/>
    <p:sldLayoutId id="2147483684" r:id="rId36"/>
    <p:sldLayoutId id="2147483685" r:id="rId37"/>
    <p:sldLayoutId id="2147483686" r:id="rId38"/>
    <p:sldLayoutId id="2147483687" r:id="rId39"/>
    <p:sldLayoutId id="2147483688" r:id="rId40"/>
    <p:sldLayoutId id="2147483689" r:id="rId41"/>
    <p:sldLayoutId id="2147483690" r:id="rId42"/>
    <p:sldLayoutId id="2147483691" r:id="rId43"/>
    <p:sldLayoutId id="2147483692" r:id="rId44"/>
    <p:sldLayoutId id="2147483693" r:id="rId45"/>
    <p:sldLayoutId id="2147483694" r:id="rId46"/>
    <p:sldLayoutId id="2147483695" r:id="rId47"/>
    <p:sldLayoutId id="2147483696" r:id="rId48"/>
    <p:sldLayoutId id="2147483697" r:id="rId49"/>
    <p:sldLayoutId id="2147483698" r:id="rId50"/>
    <p:sldLayoutId id="2147483699" r:id="rId51"/>
    <p:sldLayoutId id="2147483700" r:id="rId52"/>
    <p:sldLayoutId id="2147483701" r:id="rId53"/>
    <p:sldLayoutId id="2147483702" r:id="rId54"/>
    <p:sldLayoutId id="2147483703" r:id="rId55"/>
    <p:sldLayoutId id="2147483704" r:id="rId56"/>
    <p:sldLayoutId id="2147483705" r:id="rId57"/>
    <p:sldLayoutId id="2147483706" r:id="rId58"/>
    <p:sldLayoutId id="2147483707" r:id="rId59"/>
    <p:sldLayoutId id="2147483708" r:id="rId60"/>
    <p:sldLayoutId id="2147483709" r:id="rId61"/>
    <p:sldLayoutId id="2147483710" r:id="rId62"/>
    <p:sldLayoutId id="2147483711" r:id="rId63"/>
    <p:sldLayoutId id="2147483712" r:id="rId64"/>
    <p:sldLayoutId id="2147483713" r:id="rId65"/>
    <p:sldLayoutId id="2147483714" r:id="rId66"/>
    <p:sldLayoutId id="2147483715" r:id="rId67"/>
    <p:sldLayoutId id="2147483716" r:id="rId68"/>
    <p:sldLayoutId id="2147483717" r:id="rId69"/>
    <p:sldLayoutId id="2147483718" r:id="rId70"/>
    <p:sldLayoutId id="2147483719" r:id="rId71"/>
    <p:sldLayoutId id="2147483720" r:id="rId72"/>
    <p:sldLayoutId id="2147483721" r:id="rId73"/>
    <p:sldLayoutId id="2147483722" r:id="rId74"/>
    <p:sldLayoutId id="2147483723" r:id="rId75"/>
    <p:sldLayoutId id="2147483724" r:id="rId76"/>
    <p:sldLayoutId id="2147483725" r:id="rId77"/>
    <p:sldLayoutId id="2147483726" r:id="rId78"/>
    <p:sldLayoutId id="2147483727" r:id="rId79"/>
    <p:sldLayoutId id="2147483728" r:id="rId80"/>
    <p:sldLayoutId id="2147483729" r:id="rId81"/>
    <p:sldLayoutId id="2147483730" r:id="rId82"/>
    <p:sldLayoutId id="2147483731" r:id="rId83"/>
    <p:sldLayoutId id="2147483732" r:id="rId84"/>
    <p:sldLayoutId id="2147483733" r:id="rId85"/>
    <p:sldLayoutId id="2147483734" r:id="rId86"/>
    <p:sldLayoutId id="2147483735" r:id="rId87"/>
    <p:sldLayoutId id="2147483736" r:id="rId88"/>
    <p:sldLayoutId id="2147483737" r:id="rId89"/>
    <p:sldLayoutId id="2147483738" r:id="rId90"/>
    <p:sldLayoutId id="2147483739" r:id="rId91"/>
    <p:sldLayoutId id="2147483740" r:id="rId92"/>
    <p:sldLayoutId id="2147483741" r:id="rId93"/>
    <p:sldLayoutId id="2147483742" r:id="rId9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jp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7" name="Google Shape;617;p1"/>
          <p:cNvSpPr txBox="1">
            <a:spLocks noGrp="1"/>
          </p:cNvSpPr>
          <p:nvPr>
            <p:ph type="body" idx="1"/>
          </p:nvPr>
        </p:nvSpPr>
        <p:spPr>
          <a:xfrm>
            <a:off x="406848" y="2884133"/>
            <a:ext cx="11226964" cy="2895079"/>
          </a:xfrm>
          <a:prstGeom prst="rect">
            <a:avLst/>
          </a:prstGeom>
          <a:solidFill>
            <a:srgbClr val="FEED99"/>
          </a:solidFill>
          <a:ln w="57150" cap="flat" cmpd="sng">
            <a:solidFill>
              <a:schemeClr val="accen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134938" lvl="0" indent="0" algn="l" rtl="0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SzPct val="88987"/>
              <a:buNone/>
            </a:pPr>
            <a:r>
              <a:rPr lang="en-US" sz="2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he University of York is doing research about the Good Life peer-tutor course.</a:t>
            </a:r>
            <a:endParaRPr sz="240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134937" lvl="0" indent="0" algn="l" rtl="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SzPct val="88987"/>
              <a:buNone/>
            </a:pPr>
            <a:r>
              <a:rPr lang="en-US" sz="2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hey are observing and voice-recording this session of the Good Life course.</a:t>
            </a:r>
            <a:endParaRPr sz="2400" dirty="0"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134937" lvl="0" indent="0" algn="ctr" rtl="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SzPct val="88987"/>
              <a:buNone/>
            </a:pPr>
            <a:r>
              <a:rPr lang="en-US" sz="2800" b="1" u="sng" dirty="0">
                <a:solidFill>
                  <a:srgbClr val="C00000"/>
                </a:solidFill>
                <a:latin typeface="Arial"/>
                <a:ea typeface="Arial"/>
                <a:cs typeface="Arial"/>
                <a:sym typeface="Arial"/>
              </a:rPr>
              <a:t>If you DO NOT want to be observed or recorded in this session please let us know</a:t>
            </a:r>
            <a:endParaRPr sz="2800" dirty="0"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134938" lvl="0" indent="0" algn="l" rtl="0">
              <a:lnSpc>
                <a:spcPct val="114000"/>
              </a:lnSpc>
              <a:spcBef>
                <a:spcPts val="1000"/>
              </a:spcBef>
              <a:spcAft>
                <a:spcPts val="0"/>
              </a:spcAft>
              <a:buSzPct val="88987"/>
              <a:buNone/>
            </a:pPr>
            <a:r>
              <a:rPr lang="en-US" sz="2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If you have any questions </a:t>
            </a:r>
            <a:r>
              <a:rPr lang="en-US" sz="2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lease ask</a:t>
            </a:r>
            <a:r>
              <a:rPr lang="en-US" sz="2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or hold up your</a:t>
            </a:r>
            <a:r>
              <a:rPr lang="en-US" sz="2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‘I want to speak’ </a:t>
            </a:r>
            <a:r>
              <a:rPr lang="en-US" sz="2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ard. </a:t>
            </a:r>
            <a:endParaRPr sz="2400" dirty="0"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618" name="Google Shape;618;p1"/>
          <p:cNvSpPr txBox="1">
            <a:spLocks noGrp="1"/>
          </p:cNvSpPr>
          <p:nvPr>
            <p:ph type="title"/>
          </p:nvPr>
        </p:nvSpPr>
        <p:spPr>
          <a:xfrm>
            <a:off x="2678394" y="752550"/>
            <a:ext cx="7403400" cy="164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b" anchorCtr="0">
            <a:noAutofit/>
          </a:bodyPr>
          <a:lstStyle/>
          <a:p>
            <a:pPr marL="0" lvl="0" indent="0" algn="ctr" rtl="0">
              <a:lnSpc>
                <a:spcPct val="88000"/>
              </a:lnSpc>
              <a:spcBef>
                <a:spcPts val="0"/>
              </a:spcBef>
              <a:spcAft>
                <a:spcPts val="0"/>
              </a:spcAft>
              <a:buSzPts val="4100"/>
              <a:buNone/>
            </a:pPr>
            <a:r>
              <a:rPr lang="en-US" sz="3600" u="sng">
                <a:solidFill>
                  <a:srgbClr val="C00000"/>
                </a:solidFill>
              </a:rPr>
              <a:t>This session is being observed and voice-recorded for research </a:t>
            </a:r>
            <a:endParaRPr sz="3600" u="sng">
              <a:solidFill>
                <a:srgbClr val="C00000"/>
              </a:solidFill>
            </a:endParaRPr>
          </a:p>
        </p:txBody>
      </p:sp>
      <p:sp>
        <p:nvSpPr>
          <p:cNvPr id="619" name="Google Shape;619;p1"/>
          <p:cNvSpPr txBox="1"/>
          <p:nvPr/>
        </p:nvSpPr>
        <p:spPr>
          <a:xfrm>
            <a:off x="3040655" y="876110"/>
            <a:ext cx="6213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134938" marR="0" lvl="0" indent="0" algn="ctr" rtl="0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Welcome to this Good Life with Dementia session</a:t>
            </a:r>
            <a:endParaRPr sz="1800" b="0" i="0" u="none" strike="noStrike" cap="none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pic>
        <p:nvPicPr>
          <p:cNvPr id="620" name="Google Shape;620;p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678394" y="231108"/>
            <a:ext cx="1413989" cy="5272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21" name="Google Shape;621;p1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06848" y="2140226"/>
            <a:ext cx="1106677" cy="386101"/>
          </a:xfrm>
          <a:prstGeom prst="rect">
            <a:avLst/>
          </a:prstGeom>
          <a:noFill/>
          <a:ln>
            <a:noFill/>
          </a:ln>
        </p:spPr>
      </p:pic>
      <p:pic>
        <p:nvPicPr>
          <p:cNvPr id="622" name="Google Shape;622;p1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84661" y="225300"/>
            <a:ext cx="1011463" cy="5272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23" name="Google Shape;623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406848" y="215950"/>
            <a:ext cx="498941" cy="536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24" name="Google Shape;624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976925" y="215950"/>
            <a:ext cx="536600" cy="536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25" name="Google Shape;625;p1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406848" y="876110"/>
            <a:ext cx="1703358" cy="111171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Brand template">
  <a:themeElements>
    <a:clrScheme name="Simple Light">
      <a:dk1>
        <a:srgbClr val="000000"/>
      </a:dk1>
      <a:lt1>
        <a:srgbClr val="FFFFFF"/>
      </a:lt1>
      <a:dk2>
        <a:srgbClr val="A6A091"/>
      </a:dk2>
      <a:lt2>
        <a:srgbClr val="EEEEEE"/>
      </a:lt2>
      <a:accent1>
        <a:srgbClr val="FD5000"/>
      </a:accent1>
      <a:accent2>
        <a:srgbClr val="FFD200"/>
      </a:accent2>
      <a:accent3>
        <a:srgbClr val="78BF26"/>
      </a:accent3>
      <a:accent4>
        <a:srgbClr val="00C2DE"/>
      </a:accent4>
      <a:accent5>
        <a:srgbClr val="001E82"/>
      </a:accent5>
      <a:accent6>
        <a:srgbClr val="3C0032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0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Times New Roman</vt:lpstr>
      <vt:lpstr>Inter SemiBold</vt:lpstr>
      <vt:lpstr>Calibri</vt:lpstr>
      <vt:lpstr>Roboto Condensed</vt:lpstr>
      <vt:lpstr>Arial</vt:lpstr>
      <vt:lpstr>Inter</vt:lpstr>
      <vt:lpstr>Hind</vt:lpstr>
      <vt:lpstr>Bebas Neue</vt:lpstr>
      <vt:lpstr>Brand template</vt:lpstr>
      <vt:lpstr>This session is being observed and voice-recorded for research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is session is being observed and voice-recorded for research</dc:title>
  <dc:creator>Kate Gridley</dc:creator>
  <cp:lastModifiedBy>Kate Gridley</cp:lastModifiedBy>
  <cp:revision>2</cp:revision>
  <dcterms:created xsi:type="dcterms:W3CDTF">2023-05-24T13:29:44Z</dcterms:created>
  <dcterms:modified xsi:type="dcterms:W3CDTF">2026-05-22T17:30:59Z</dcterms:modified>
</cp:coreProperties>
</file>